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drawings/drawing1.xml" ContentType="application/vnd.openxmlformats-officedocument.drawingml.chartshapes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drawings/drawing2.xml" ContentType="application/vnd.openxmlformats-officedocument.drawingml.chartshapes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drawings/drawing3.xml" ContentType="application/vnd.openxmlformats-officedocument.drawingml.chartshapes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drawings/drawing4.xml" ContentType="application/vnd.openxmlformats-officedocument.drawingml.chartshapes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drawings/drawing5.xml" ContentType="application/vnd.openxmlformats-officedocument.drawingml.chartshapes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sldIdLst>
    <p:sldId id="266" r:id="rId3"/>
    <p:sldId id="267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5" d="100"/>
          <a:sy n="75" d="100"/>
        </p:scale>
        <p:origin x="874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2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9.xlsx"/><Relationship Id="rId2" Type="http://schemas.microsoft.com/office/2011/relationships/chartColorStyle" Target="colors10.xml"/><Relationship Id="rId1" Type="http://schemas.microsoft.com/office/2011/relationships/chartStyle" Target="style10.xml"/><Relationship Id="rId4" Type="http://schemas.openxmlformats.org/officeDocument/2006/relationships/chartUserShapes" Target="../drawings/drawing1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0.xlsx"/><Relationship Id="rId2" Type="http://schemas.microsoft.com/office/2011/relationships/chartColorStyle" Target="colors11.xml"/><Relationship Id="rId1" Type="http://schemas.microsoft.com/office/2011/relationships/chartStyle" Target="style11.xml"/><Relationship Id="rId4" Type="http://schemas.openxmlformats.org/officeDocument/2006/relationships/chartUserShapes" Target="../drawings/drawing2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1.xlsx"/><Relationship Id="rId2" Type="http://schemas.microsoft.com/office/2011/relationships/chartColorStyle" Target="colors12.xml"/><Relationship Id="rId1" Type="http://schemas.microsoft.com/office/2011/relationships/chartStyle" Target="style12.xml"/><Relationship Id="rId4" Type="http://schemas.openxmlformats.org/officeDocument/2006/relationships/chartUserShapes" Target="../drawings/drawing3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2.xlsx"/><Relationship Id="rId2" Type="http://schemas.microsoft.com/office/2011/relationships/chartColorStyle" Target="colors13.xml"/><Relationship Id="rId1" Type="http://schemas.microsoft.com/office/2011/relationships/chartStyle" Target="style13.xml"/><Relationship Id="rId4" Type="http://schemas.openxmlformats.org/officeDocument/2006/relationships/chartUserShapes" Target="../drawings/drawing4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3.xlsx"/><Relationship Id="rId2" Type="http://schemas.microsoft.com/office/2011/relationships/chartColorStyle" Target="colors14.xml"/><Relationship Id="rId1" Type="http://schemas.microsoft.com/office/2011/relationships/chartStyle" Target="style14.xml"/><Relationship Id="rId4" Type="http://schemas.openxmlformats.org/officeDocument/2006/relationships/chartUserShapes" Target="../drawings/drawing5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4.xlsx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5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6.xlsx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7.xlsx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8.xlsx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b="1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HL</a:t>
            </a:r>
          </a:p>
        </c:rich>
      </c:tx>
      <c:layout>
        <c:manualLayout>
          <c:xMode val="edge"/>
          <c:yMode val="edge"/>
          <c:x val="4.1645669291338575E-2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view3D>
      <c:rotX val="15"/>
      <c:rotY val="20"/>
      <c:depthPercent val="100"/>
      <c:rAngAx val="1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>
        <c:manualLayout>
          <c:layoutTarget val="inner"/>
          <c:xMode val="edge"/>
          <c:yMode val="edge"/>
          <c:x val="5.5738118572088366E-2"/>
          <c:y val="8.8425925925925922E-2"/>
          <c:w val="0.90512270341207346"/>
          <c:h val="0.62923410615339748"/>
        </c:manualLayout>
      </c:layout>
      <c:bar3DChart>
        <c:barDir val="col"/>
        <c:grouping val="clustered"/>
        <c:varyColors val="0"/>
        <c:ser>
          <c:idx val="0"/>
          <c:order val="0"/>
          <c:tx>
            <c:strRef>
              <c:f>Sheet3!$Y$34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  <a:sp3d/>
          </c:spPr>
          <c:invertIfNegative val="0"/>
          <c:cat>
            <c:strRef>
              <c:f>Sheet3!$Z$33:$AG$33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3!$Z$34:$AG$34</c:f>
              <c:numCache>
                <c:formatCode>General</c:formatCode>
                <c:ptCount val="8"/>
                <c:pt idx="0">
                  <c:v>46.706000000000003</c:v>
                </c:pt>
                <c:pt idx="1">
                  <c:v>51.707000000000001</c:v>
                </c:pt>
                <c:pt idx="2">
                  <c:v>39.994</c:v>
                </c:pt>
                <c:pt idx="3">
                  <c:v>37.694000000000003</c:v>
                </c:pt>
                <c:pt idx="4">
                  <c:v>39.561</c:v>
                </c:pt>
                <c:pt idx="5">
                  <c:v>40.380000000000003</c:v>
                </c:pt>
                <c:pt idx="6">
                  <c:v>45.204999999999998</c:v>
                </c:pt>
                <c:pt idx="7">
                  <c:v>51.92799999999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5DE-47AC-9FC0-3331B10D3356}"/>
            </c:ext>
          </c:extLst>
        </c:ser>
        <c:ser>
          <c:idx val="1"/>
          <c:order val="1"/>
          <c:tx>
            <c:strRef>
              <c:f>Sheet3!$Y$35</c:f>
              <c:strCache>
                <c:ptCount val="1"/>
                <c:pt idx="0">
                  <c:v>D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  <a:sp3d/>
          </c:spPr>
          <c:invertIfNegative val="0"/>
          <c:cat>
            <c:strRef>
              <c:f>Sheet3!$Z$33:$AG$33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3!$Z$35:$AG$35</c:f>
              <c:numCache>
                <c:formatCode>General</c:formatCode>
                <c:ptCount val="8"/>
                <c:pt idx="0">
                  <c:v>37.94</c:v>
                </c:pt>
                <c:pt idx="1">
                  <c:v>40.619</c:v>
                </c:pt>
                <c:pt idx="2">
                  <c:v>36.128</c:v>
                </c:pt>
                <c:pt idx="3">
                  <c:v>37.033000000000001</c:v>
                </c:pt>
                <c:pt idx="4">
                  <c:v>37.646999999999998</c:v>
                </c:pt>
                <c:pt idx="5">
                  <c:v>39.610999999999997</c:v>
                </c:pt>
                <c:pt idx="6">
                  <c:v>40.667999999999999</c:v>
                </c:pt>
                <c:pt idx="7">
                  <c:v>44.521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5DE-47AC-9FC0-3331B10D3356}"/>
            </c:ext>
          </c:extLst>
        </c:ser>
        <c:ser>
          <c:idx val="2"/>
          <c:order val="2"/>
          <c:tx>
            <c:strRef>
              <c:f>Sheet3!$Y$36</c:f>
              <c:strCache>
                <c:ptCount val="1"/>
                <c:pt idx="0">
                  <c:v>NSA</c:v>
                </c:pt>
              </c:strCache>
            </c:strRef>
          </c:tx>
          <c:spPr>
            <a:solidFill>
              <a:srgbClr val="002060"/>
            </a:solidFill>
            <a:ln>
              <a:noFill/>
            </a:ln>
            <a:effectLst/>
            <a:sp3d/>
          </c:spPr>
          <c:invertIfNegative val="0"/>
          <c:cat>
            <c:strRef>
              <c:f>Sheet3!$Z$33:$AG$33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3!$Z$36:$AG$36</c:f>
              <c:numCache>
                <c:formatCode>General</c:formatCode>
                <c:ptCount val="8"/>
                <c:pt idx="0">
                  <c:v>45.404000000000003</c:v>
                </c:pt>
                <c:pt idx="1">
                  <c:v>49.195999999999998</c:v>
                </c:pt>
                <c:pt idx="2">
                  <c:v>38.582999999999998</c:v>
                </c:pt>
                <c:pt idx="3">
                  <c:v>33.823</c:v>
                </c:pt>
                <c:pt idx="4">
                  <c:v>38.692</c:v>
                </c:pt>
                <c:pt idx="5">
                  <c:v>46.48</c:v>
                </c:pt>
                <c:pt idx="6">
                  <c:v>44.639000000000003</c:v>
                </c:pt>
                <c:pt idx="7">
                  <c:v>44.094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5DE-47AC-9FC0-3331B10D3356}"/>
            </c:ext>
          </c:extLst>
        </c:ser>
        <c:ser>
          <c:idx val="3"/>
          <c:order val="3"/>
          <c:tx>
            <c:strRef>
              <c:f>Sheet3!$Y$37</c:f>
              <c:strCache>
                <c:ptCount val="1"/>
                <c:pt idx="0">
                  <c:v>DSA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  <a:sp3d/>
          </c:spPr>
          <c:invertIfNegative val="0"/>
          <c:cat>
            <c:strRef>
              <c:f>Sheet3!$Z$33:$AG$33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3!$Z$37:$AG$37</c:f>
              <c:numCache>
                <c:formatCode>General</c:formatCode>
                <c:ptCount val="8"/>
                <c:pt idx="0">
                  <c:v>42.509</c:v>
                </c:pt>
                <c:pt idx="1">
                  <c:v>42.033000000000001</c:v>
                </c:pt>
                <c:pt idx="2">
                  <c:v>34.229999999999997</c:v>
                </c:pt>
                <c:pt idx="3">
                  <c:v>42.253999999999998</c:v>
                </c:pt>
                <c:pt idx="4">
                  <c:v>21.646000000000001</c:v>
                </c:pt>
                <c:pt idx="5">
                  <c:v>41.652999999999999</c:v>
                </c:pt>
                <c:pt idx="6">
                  <c:v>33.520000000000003</c:v>
                </c:pt>
                <c:pt idx="7">
                  <c:v>37.4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75DE-47AC-9FC0-3331B10D335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592933832"/>
        <c:axId val="592936352"/>
        <c:axId val="0"/>
      </c:bar3DChart>
      <c:catAx>
        <c:axId val="5929338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5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92936352"/>
        <c:crosses val="autoZero"/>
        <c:auto val="1"/>
        <c:lblAlgn val="ctr"/>
        <c:lblOffset val="100"/>
        <c:noMultiLvlLbl val="0"/>
      </c:catAx>
      <c:valAx>
        <c:axId val="59293635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9293383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2520496096786182"/>
          <c:y val="7.4697433654126524E-2"/>
          <c:w val="0.28294685039370077"/>
          <c:h val="7.345071449402157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b="1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G</a:t>
            </a:r>
          </a:p>
        </c:rich>
      </c:tx>
      <c:layout>
        <c:manualLayout>
          <c:xMode val="edge"/>
          <c:yMode val="edge"/>
          <c:x val="9.8667755867432455E-2"/>
          <c:y val="5.975858433274078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view3D>
      <c:rotX val="15"/>
      <c:rotY val="20"/>
      <c:depthPercent val="100"/>
      <c:rAngAx val="1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>
        <c:manualLayout>
          <c:layoutTarget val="inner"/>
          <c:xMode val="edge"/>
          <c:yMode val="edge"/>
          <c:x val="7.2214327224511363E-2"/>
          <c:y val="0.16946915227657747"/>
          <c:w val="0.9019495533380244"/>
          <c:h val="0.64723426142065343"/>
        </c:manualLayout>
      </c:layout>
      <c:bar3DChart>
        <c:barDir val="col"/>
        <c:grouping val="clustered"/>
        <c:varyColors val="0"/>
        <c:ser>
          <c:idx val="0"/>
          <c:order val="0"/>
          <c:tx>
            <c:strRef>
              <c:f>Sheet4!$O$7</c:f>
              <c:strCache>
                <c:ptCount val="1"/>
                <c:pt idx="0">
                  <c:v>NI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  <a:sp3d/>
          </c:spPr>
          <c:invertIfNegative val="0"/>
          <c:cat>
            <c:strRef>
              <c:f>Sheet4!$P$6:$W$6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4!$P$7:$W$7</c:f>
              <c:numCache>
                <c:formatCode>General</c:formatCode>
                <c:ptCount val="8"/>
                <c:pt idx="0">
                  <c:v>15</c:v>
                </c:pt>
                <c:pt idx="1">
                  <c:v>18.3</c:v>
                </c:pt>
                <c:pt idx="2">
                  <c:v>13.5</c:v>
                </c:pt>
                <c:pt idx="3">
                  <c:v>16.2</c:v>
                </c:pt>
                <c:pt idx="4">
                  <c:v>14.2</c:v>
                </c:pt>
                <c:pt idx="5">
                  <c:v>12.9</c:v>
                </c:pt>
                <c:pt idx="6">
                  <c:v>13.5</c:v>
                </c:pt>
                <c:pt idx="7">
                  <c:v>18.89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BDE-4306-A746-13D9188D0AC5}"/>
            </c:ext>
          </c:extLst>
        </c:ser>
        <c:ser>
          <c:idx val="1"/>
          <c:order val="1"/>
          <c:tx>
            <c:strRef>
              <c:f>Sheet4!$O$8</c:f>
              <c:strCache>
                <c:ptCount val="1"/>
                <c:pt idx="0">
                  <c:v>D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  <a:sp3d/>
          </c:spPr>
          <c:invertIfNegative val="0"/>
          <c:cat>
            <c:strRef>
              <c:f>Sheet4!$P$6:$W$6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4!$P$8:$W$8</c:f>
              <c:numCache>
                <c:formatCode>General</c:formatCode>
                <c:ptCount val="8"/>
                <c:pt idx="0">
                  <c:v>7.8</c:v>
                </c:pt>
                <c:pt idx="1">
                  <c:v>15.4</c:v>
                </c:pt>
                <c:pt idx="2">
                  <c:v>13.3</c:v>
                </c:pt>
                <c:pt idx="3">
                  <c:v>7.6</c:v>
                </c:pt>
                <c:pt idx="4">
                  <c:v>12.1</c:v>
                </c:pt>
                <c:pt idx="5">
                  <c:v>5.8</c:v>
                </c:pt>
                <c:pt idx="6">
                  <c:v>10.6</c:v>
                </c:pt>
                <c:pt idx="7">
                  <c:v>10.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BDE-4306-A746-13D9188D0AC5}"/>
            </c:ext>
          </c:extLst>
        </c:ser>
        <c:ser>
          <c:idx val="2"/>
          <c:order val="2"/>
          <c:tx>
            <c:strRef>
              <c:f>Sheet4!$O$9</c:f>
              <c:strCache>
                <c:ptCount val="1"/>
                <c:pt idx="0">
                  <c:v>NSA</c:v>
                </c:pt>
              </c:strCache>
            </c:strRef>
          </c:tx>
          <c:spPr>
            <a:solidFill>
              <a:srgbClr val="002060"/>
            </a:solidFill>
            <a:ln>
              <a:noFill/>
            </a:ln>
            <a:effectLst/>
            <a:sp3d/>
          </c:spPr>
          <c:invertIfNegative val="0"/>
          <c:cat>
            <c:strRef>
              <c:f>Sheet4!$P$6:$W$6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4!$P$9:$W$9</c:f>
              <c:numCache>
                <c:formatCode>General</c:formatCode>
                <c:ptCount val="8"/>
                <c:pt idx="0">
                  <c:v>16</c:v>
                </c:pt>
                <c:pt idx="1">
                  <c:v>23.1</c:v>
                </c:pt>
                <c:pt idx="2">
                  <c:v>17.100000000000001</c:v>
                </c:pt>
                <c:pt idx="3">
                  <c:v>13.2</c:v>
                </c:pt>
                <c:pt idx="4">
                  <c:v>19.7</c:v>
                </c:pt>
                <c:pt idx="5">
                  <c:v>15</c:v>
                </c:pt>
                <c:pt idx="6">
                  <c:v>15.3</c:v>
                </c:pt>
                <c:pt idx="7">
                  <c:v>20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BDE-4306-A746-13D9188D0AC5}"/>
            </c:ext>
          </c:extLst>
        </c:ser>
        <c:ser>
          <c:idx val="3"/>
          <c:order val="3"/>
          <c:tx>
            <c:strRef>
              <c:f>Sheet4!$O$10</c:f>
              <c:strCache>
                <c:ptCount val="1"/>
                <c:pt idx="0">
                  <c:v>DSA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  <a:sp3d/>
          </c:spPr>
          <c:invertIfNegative val="0"/>
          <c:cat>
            <c:strRef>
              <c:f>Sheet4!$P$6:$W$6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4!$P$10:$W$10</c:f>
              <c:numCache>
                <c:formatCode>General</c:formatCode>
                <c:ptCount val="8"/>
                <c:pt idx="0">
                  <c:v>17.8</c:v>
                </c:pt>
                <c:pt idx="1">
                  <c:v>20.9</c:v>
                </c:pt>
                <c:pt idx="2">
                  <c:v>13.1</c:v>
                </c:pt>
                <c:pt idx="3">
                  <c:v>9.4</c:v>
                </c:pt>
                <c:pt idx="4">
                  <c:v>11.7</c:v>
                </c:pt>
                <c:pt idx="5">
                  <c:v>9</c:v>
                </c:pt>
                <c:pt idx="6">
                  <c:v>14.1</c:v>
                </c:pt>
                <c:pt idx="7">
                  <c:v>20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5BDE-4306-A746-13D9188D0AC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587794816"/>
        <c:axId val="587789416"/>
        <c:axId val="0"/>
      </c:bar3DChart>
      <c:catAx>
        <c:axId val="5877948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5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87789416"/>
        <c:crosses val="autoZero"/>
        <c:auto val="1"/>
        <c:lblAlgn val="ctr"/>
        <c:lblOffset val="100"/>
        <c:noMultiLvlLbl val="0"/>
      </c:catAx>
      <c:valAx>
        <c:axId val="58778941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8779481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1102646544181982"/>
          <c:y val="0.1024752114319043"/>
          <c:w val="0.29567898321269226"/>
          <c:h val="7.247137867904915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b="1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rbs</a:t>
            </a:r>
          </a:p>
        </c:rich>
      </c:tx>
      <c:layout>
        <c:manualLayout>
          <c:xMode val="edge"/>
          <c:yMode val="edge"/>
          <c:x val="0.10469156909037657"/>
          <c:y val="3.56340425953099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view3D>
      <c:rotX val="15"/>
      <c:rotY val="20"/>
      <c:depthPercent val="100"/>
      <c:rAngAx val="1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/>
      <c:bar3DChart>
        <c:barDir val="col"/>
        <c:grouping val="clustered"/>
        <c:varyColors val="0"/>
        <c:ser>
          <c:idx val="0"/>
          <c:order val="0"/>
          <c:tx>
            <c:strRef>
              <c:f>Sheet4!$O$17</c:f>
              <c:strCache>
                <c:ptCount val="1"/>
                <c:pt idx="0">
                  <c:v>NI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  <a:sp3d/>
          </c:spPr>
          <c:invertIfNegative val="0"/>
          <c:cat>
            <c:strRef>
              <c:f>Sheet4!$P$16:$W$16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4!$P$17:$W$17</c:f>
              <c:numCache>
                <c:formatCode>0.00</c:formatCode>
                <c:ptCount val="8"/>
                <c:pt idx="0">
                  <c:v>610.39939713639797</c:v>
                </c:pt>
                <c:pt idx="1">
                  <c:v>749.81160512434008</c:v>
                </c:pt>
                <c:pt idx="2">
                  <c:v>41.446872645063671</c:v>
                </c:pt>
                <c:pt idx="3">
                  <c:v>135.6443104747552</c:v>
                </c:pt>
                <c:pt idx="4">
                  <c:v>116.80482290881656</c:v>
                </c:pt>
                <c:pt idx="5">
                  <c:v>414.46872645064013</c:v>
                </c:pt>
                <c:pt idx="6">
                  <c:v>120.57272042200464</c:v>
                </c:pt>
                <c:pt idx="7">
                  <c:v>188.394875659382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EFD-4370-9707-1625E690A7DC}"/>
            </c:ext>
          </c:extLst>
        </c:ser>
        <c:ser>
          <c:idx val="1"/>
          <c:order val="1"/>
          <c:tx>
            <c:strRef>
              <c:f>Sheet4!$O$18</c:f>
              <c:strCache>
                <c:ptCount val="1"/>
                <c:pt idx="0">
                  <c:v>D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  <a:sp3d/>
          </c:spPr>
          <c:invertIfNegative val="0"/>
          <c:cat>
            <c:strRef>
              <c:f>Sheet4!$P$16:$W$16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4!$P$18:$W$18</c:f>
              <c:numCache>
                <c:formatCode>0.00</c:formatCode>
                <c:ptCount val="8"/>
                <c:pt idx="0">
                  <c:v>173.32328560663169</c:v>
                </c:pt>
                <c:pt idx="1">
                  <c:v>286.36021100226014</c:v>
                </c:pt>
                <c:pt idx="2">
                  <c:v>143.1801055011305</c:v>
                </c:pt>
                <c:pt idx="3">
                  <c:v>327.80708364732459</c:v>
                </c:pt>
                <c:pt idx="4">
                  <c:v>312.73549359457411</c:v>
                </c:pt>
                <c:pt idx="5">
                  <c:v>271.28862094950955</c:v>
                </c:pt>
                <c:pt idx="6">
                  <c:v>614.16729464958576</c:v>
                </c:pt>
                <c:pt idx="7">
                  <c:v>399.397136397889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EFD-4370-9707-1625E690A7DC}"/>
            </c:ext>
          </c:extLst>
        </c:ser>
        <c:ser>
          <c:idx val="2"/>
          <c:order val="2"/>
          <c:tx>
            <c:strRef>
              <c:f>Sheet4!$O$19</c:f>
              <c:strCache>
                <c:ptCount val="1"/>
                <c:pt idx="0">
                  <c:v>NSA</c:v>
                </c:pt>
              </c:strCache>
            </c:strRef>
          </c:tx>
          <c:spPr>
            <a:solidFill>
              <a:srgbClr val="002060"/>
            </a:solidFill>
            <a:ln>
              <a:noFill/>
            </a:ln>
            <a:effectLst/>
            <a:sp3d/>
          </c:spPr>
          <c:invertIfNegative val="0"/>
          <c:cat>
            <c:strRef>
              <c:f>Sheet4!$P$16:$W$16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4!$P$19:$W$19</c:f>
              <c:numCache>
                <c:formatCode>0.00</c:formatCode>
                <c:ptCount val="8"/>
                <c:pt idx="0">
                  <c:v>406.93293142426478</c:v>
                </c:pt>
                <c:pt idx="1">
                  <c:v>591.55990957045981</c:v>
                </c:pt>
                <c:pt idx="2">
                  <c:v>678.22155237377513</c:v>
                </c:pt>
                <c:pt idx="3">
                  <c:v>214.77015825169531</c:v>
                </c:pt>
                <c:pt idx="4">
                  <c:v>256.21703089675987</c:v>
                </c:pt>
                <c:pt idx="5">
                  <c:v>120.57272042200464</c:v>
                </c:pt>
                <c:pt idx="6">
                  <c:v>143.1801055011305</c:v>
                </c:pt>
                <c:pt idx="7">
                  <c:v>211.002260738508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EFD-4370-9707-1625E690A7DC}"/>
            </c:ext>
          </c:extLst>
        </c:ser>
        <c:ser>
          <c:idx val="3"/>
          <c:order val="3"/>
          <c:tx>
            <c:strRef>
              <c:f>Sheet4!$O$20</c:f>
              <c:strCache>
                <c:ptCount val="1"/>
                <c:pt idx="0">
                  <c:v>DSA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  <a:sp3d/>
          </c:spPr>
          <c:invertIfNegative val="0"/>
          <c:cat>
            <c:strRef>
              <c:f>Sheet4!$P$16:$W$16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4!$P$20:$W$20</c:f>
              <c:numCache>
                <c:formatCode>0.00</c:formatCode>
                <c:ptCount val="8"/>
                <c:pt idx="0">
                  <c:v>448.37980406932928</c:v>
                </c:pt>
                <c:pt idx="1">
                  <c:v>335.34287867369994</c:v>
                </c:pt>
                <c:pt idx="2">
                  <c:v>357.95026375282583</c:v>
                </c:pt>
                <c:pt idx="3">
                  <c:v>82.89374529012818</c:v>
                </c:pt>
                <c:pt idx="4">
                  <c:v>399.39713639788954</c:v>
                </c:pt>
                <c:pt idx="5">
                  <c:v>241.14544084400927</c:v>
                </c:pt>
                <c:pt idx="6">
                  <c:v>45.214770158251739</c:v>
                </c:pt>
                <c:pt idx="7">
                  <c:v>606.63149962321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4EFD-4370-9707-1625E690A7D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664908352"/>
        <c:axId val="664901872"/>
        <c:axId val="0"/>
      </c:bar3DChart>
      <c:catAx>
        <c:axId val="6649083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5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64901872"/>
        <c:crosses val="autoZero"/>
        <c:auto val="1"/>
        <c:lblAlgn val="ctr"/>
        <c:lblOffset val="100"/>
        <c:noMultiLvlLbl val="0"/>
      </c:catAx>
      <c:valAx>
        <c:axId val="664901872"/>
        <c:scaling>
          <c:orientation val="minMax"/>
        </c:scaling>
        <c:delete val="0"/>
        <c:axPos val="l"/>
        <c:numFmt formatCode="0" sourceLinked="0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6490835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5991921122985896"/>
          <c:y val="0.11940494248123742"/>
          <c:w val="0.29554546784995467"/>
          <c:h val="7.247137867904915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b="1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oT</a:t>
            </a:r>
          </a:p>
        </c:rich>
      </c:tx>
      <c:layout>
        <c:manualLayout>
          <c:xMode val="edge"/>
          <c:yMode val="edge"/>
          <c:x val="0.10437489063867016"/>
          <c:y val="3.703717693630467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view3D>
      <c:rotX val="15"/>
      <c:rotY val="20"/>
      <c:depthPercent val="100"/>
      <c:rAngAx val="1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/>
      <c:bar3DChart>
        <c:barDir val="col"/>
        <c:grouping val="clustered"/>
        <c:varyColors val="0"/>
        <c:ser>
          <c:idx val="0"/>
          <c:order val="0"/>
          <c:tx>
            <c:strRef>
              <c:f>Sheet4!$O$22</c:f>
              <c:strCache>
                <c:ptCount val="1"/>
                <c:pt idx="0">
                  <c:v>NI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  <a:sp3d/>
          </c:spPr>
          <c:invertIfNegative val="0"/>
          <c:cat>
            <c:strRef>
              <c:f>Sheet4!$P$21:$W$21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4!$P$22:$W$22</c:f>
              <c:numCache>
                <c:formatCode>0.00</c:formatCode>
                <c:ptCount val="8"/>
                <c:pt idx="0">
                  <c:v>0.50406504065040647</c:v>
                </c:pt>
                <c:pt idx="1">
                  <c:v>0.71544715447154472</c:v>
                </c:pt>
                <c:pt idx="2">
                  <c:v>0.63414634146341464</c:v>
                </c:pt>
                <c:pt idx="3">
                  <c:v>0.45528455284552849</c:v>
                </c:pt>
                <c:pt idx="4">
                  <c:v>0.91056910569105698</c:v>
                </c:pt>
                <c:pt idx="5">
                  <c:v>0.82926829268292668</c:v>
                </c:pt>
                <c:pt idx="6">
                  <c:v>0.45528455284552849</c:v>
                </c:pt>
                <c:pt idx="7">
                  <c:v>0.796747967479674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0F2-45A7-91B5-E7BC47266C5C}"/>
            </c:ext>
          </c:extLst>
        </c:ser>
        <c:ser>
          <c:idx val="1"/>
          <c:order val="1"/>
          <c:tx>
            <c:strRef>
              <c:f>Sheet4!$O$23</c:f>
              <c:strCache>
                <c:ptCount val="1"/>
                <c:pt idx="0">
                  <c:v>D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  <a:sp3d/>
          </c:spPr>
          <c:invertIfNegative val="0"/>
          <c:cat>
            <c:strRef>
              <c:f>Sheet4!$P$21:$W$21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4!$P$23:$W$23</c:f>
              <c:numCache>
                <c:formatCode>0.00</c:formatCode>
                <c:ptCount val="8"/>
                <c:pt idx="0">
                  <c:v>0.69918699186991873</c:v>
                </c:pt>
                <c:pt idx="1">
                  <c:v>0.78048780487804881</c:v>
                </c:pt>
                <c:pt idx="2">
                  <c:v>0.45528455284552849</c:v>
                </c:pt>
                <c:pt idx="3">
                  <c:v>0.66666666666666663</c:v>
                </c:pt>
                <c:pt idx="4">
                  <c:v>1.2520325203252034</c:v>
                </c:pt>
                <c:pt idx="5">
                  <c:v>1.1219512195121952</c:v>
                </c:pt>
                <c:pt idx="6">
                  <c:v>0.87804878048780477</c:v>
                </c:pt>
                <c:pt idx="7">
                  <c:v>0.845528455284552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0F2-45A7-91B5-E7BC47266C5C}"/>
            </c:ext>
          </c:extLst>
        </c:ser>
        <c:ser>
          <c:idx val="2"/>
          <c:order val="2"/>
          <c:tx>
            <c:strRef>
              <c:f>Sheet4!$O$24</c:f>
              <c:strCache>
                <c:ptCount val="1"/>
                <c:pt idx="0">
                  <c:v>NSA</c:v>
                </c:pt>
              </c:strCache>
            </c:strRef>
          </c:tx>
          <c:spPr>
            <a:solidFill>
              <a:srgbClr val="002060"/>
            </a:solidFill>
            <a:ln>
              <a:noFill/>
            </a:ln>
            <a:effectLst/>
            <a:sp3d/>
          </c:spPr>
          <c:invertIfNegative val="0"/>
          <c:cat>
            <c:strRef>
              <c:f>Sheet4!$P$21:$W$21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4!$P$24:$W$24</c:f>
              <c:numCache>
                <c:formatCode>0.00</c:formatCode>
                <c:ptCount val="8"/>
                <c:pt idx="0">
                  <c:v>0.76422764227642281</c:v>
                </c:pt>
                <c:pt idx="1">
                  <c:v>0.55284552845528456</c:v>
                </c:pt>
                <c:pt idx="2">
                  <c:v>0.73170731707317072</c:v>
                </c:pt>
                <c:pt idx="3">
                  <c:v>1.0406504065040649</c:v>
                </c:pt>
                <c:pt idx="4">
                  <c:v>0.91056910569105698</c:v>
                </c:pt>
                <c:pt idx="5">
                  <c:v>1.0081300813008129</c:v>
                </c:pt>
                <c:pt idx="6">
                  <c:v>0.89430894308943087</c:v>
                </c:pt>
                <c:pt idx="7">
                  <c:v>1.00813008130081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0F2-45A7-91B5-E7BC47266C5C}"/>
            </c:ext>
          </c:extLst>
        </c:ser>
        <c:ser>
          <c:idx val="3"/>
          <c:order val="3"/>
          <c:tx>
            <c:strRef>
              <c:f>Sheet4!$O$25</c:f>
              <c:strCache>
                <c:ptCount val="1"/>
                <c:pt idx="0">
                  <c:v>DSA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  <a:sp3d/>
          </c:spPr>
          <c:invertIfNegative val="0"/>
          <c:cat>
            <c:strRef>
              <c:f>Sheet4!$P$21:$W$21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4!$P$25:$W$25</c:f>
              <c:numCache>
                <c:formatCode>0.00</c:formatCode>
                <c:ptCount val="8"/>
                <c:pt idx="0">
                  <c:v>0.86178861788617889</c:v>
                </c:pt>
                <c:pt idx="1">
                  <c:v>0.58536585365853655</c:v>
                </c:pt>
                <c:pt idx="2">
                  <c:v>0.43902439024390238</c:v>
                </c:pt>
                <c:pt idx="3">
                  <c:v>0.86178861788617889</c:v>
                </c:pt>
                <c:pt idx="4">
                  <c:v>1.3008130081300815</c:v>
                </c:pt>
                <c:pt idx="5">
                  <c:v>0.82926829268292668</c:v>
                </c:pt>
                <c:pt idx="6">
                  <c:v>1.089430894308943</c:v>
                </c:pt>
                <c:pt idx="7">
                  <c:v>0.715447154471544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0F2-45A7-91B5-E7BC47266C5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428902088"/>
        <c:axId val="428903888"/>
        <c:axId val="0"/>
      </c:bar3DChart>
      <c:catAx>
        <c:axId val="4289020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5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8903888"/>
        <c:crosses val="autoZero"/>
        <c:auto val="1"/>
        <c:lblAlgn val="ctr"/>
        <c:lblOffset val="100"/>
        <c:noMultiLvlLbl val="0"/>
      </c:catAx>
      <c:valAx>
        <c:axId val="428903888"/>
        <c:scaling>
          <c:orientation val="minMax"/>
        </c:scaling>
        <c:delete val="0"/>
        <c:axPos val="l"/>
        <c:numFmt formatCode="0.00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890208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3291185476815404"/>
          <c:y val="8.3911490230387839E-2"/>
          <c:w val="0.29461351706036748"/>
          <c:h val="7.345071449402157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b="1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oL</a:t>
            </a:r>
          </a:p>
        </c:rich>
      </c:tx>
      <c:layout>
        <c:manualLayout>
          <c:xMode val="edge"/>
          <c:yMode val="edge"/>
          <c:x val="0.10709284291862822"/>
          <c:y val="3.303955536375365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view3D>
      <c:rotX val="15"/>
      <c:rotY val="20"/>
      <c:depthPercent val="100"/>
      <c:rAngAx val="1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>
        <c:manualLayout>
          <c:layoutTarget val="inner"/>
          <c:xMode val="edge"/>
          <c:yMode val="edge"/>
          <c:x val="7.8574411071038547E-2"/>
          <c:y val="0.14431413876909141"/>
          <c:w val="0.89228886196991819"/>
          <c:h val="0.69127533256591589"/>
        </c:manualLayout>
      </c:layout>
      <c:bar3DChart>
        <c:barDir val="col"/>
        <c:grouping val="clustered"/>
        <c:varyColors val="0"/>
        <c:ser>
          <c:idx val="0"/>
          <c:order val="0"/>
          <c:tx>
            <c:strRef>
              <c:f>Sheet4!$O$27</c:f>
              <c:strCache>
                <c:ptCount val="1"/>
                <c:pt idx="0">
                  <c:v>NI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  <a:sp3d/>
          </c:spPr>
          <c:invertIfNegative val="0"/>
          <c:cat>
            <c:strRef>
              <c:f>Sheet4!$P$26:$W$26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4!$P$27:$W$27</c:f>
              <c:numCache>
                <c:formatCode>0.00</c:formatCode>
                <c:ptCount val="8"/>
                <c:pt idx="0">
                  <c:v>419.35483870967744</c:v>
                </c:pt>
                <c:pt idx="1">
                  <c:v>509.67741935483872</c:v>
                </c:pt>
                <c:pt idx="2">
                  <c:v>400</c:v>
                </c:pt>
                <c:pt idx="3">
                  <c:v>335.48387096774195</c:v>
                </c:pt>
                <c:pt idx="4">
                  <c:v>503.22580645161287</c:v>
                </c:pt>
                <c:pt idx="5">
                  <c:v>567.74193548387086</c:v>
                </c:pt>
                <c:pt idx="6">
                  <c:v>316.12903225806457</c:v>
                </c:pt>
                <c:pt idx="7">
                  <c:v>574.193548387096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DF7-4A5D-ABEC-47CC55465543}"/>
            </c:ext>
          </c:extLst>
        </c:ser>
        <c:ser>
          <c:idx val="1"/>
          <c:order val="1"/>
          <c:tx>
            <c:strRef>
              <c:f>Sheet4!$O$28</c:f>
              <c:strCache>
                <c:ptCount val="1"/>
                <c:pt idx="0">
                  <c:v>D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  <a:sp3d/>
          </c:spPr>
          <c:invertIfNegative val="0"/>
          <c:cat>
            <c:strRef>
              <c:f>Sheet4!$P$26:$W$26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4!$P$28:$W$28</c:f>
              <c:numCache>
                <c:formatCode>0.00</c:formatCode>
                <c:ptCount val="8"/>
                <c:pt idx="0">
                  <c:v>541.9354838709678</c:v>
                </c:pt>
                <c:pt idx="1">
                  <c:v>535.48387096774195</c:v>
                </c:pt>
                <c:pt idx="2">
                  <c:v>406.45161290322574</c:v>
                </c:pt>
                <c:pt idx="3">
                  <c:v>458.0645161290322</c:v>
                </c:pt>
                <c:pt idx="4">
                  <c:v>574.19354838709671</c:v>
                </c:pt>
                <c:pt idx="5">
                  <c:v>425.80645161290329</c:v>
                </c:pt>
                <c:pt idx="6">
                  <c:v>419.35483870967744</c:v>
                </c:pt>
                <c:pt idx="7">
                  <c:v>516.1290322580645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DF7-4A5D-ABEC-47CC55465543}"/>
            </c:ext>
          </c:extLst>
        </c:ser>
        <c:ser>
          <c:idx val="2"/>
          <c:order val="2"/>
          <c:tx>
            <c:strRef>
              <c:f>Sheet4!$O$29</c:f>
              <c:strCache>
                <c:ptCount val="1"/>
                <c:pt idx="0">
                  <c:v>NSA</c:v>
                </c:pt>
              </c:strCache>
            </c:strRef>
          </c:tx>
          <c:spPr>
            <a:solidFill>
              <a:srgbClr val="002060"/>
            </a:solidFill>
            <a:ln>
              <a:noFill/>
            </a:ln>
            <a:effectLst/>
            <a:sp3d/>
          </c:spPr>
          <c:invertIfNegative val="0"/>
          <c:cat>
            <c:strRef>
              <c:f>Sheet4!$P$26:$W$26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4!$P$29:$W$29</c:f>
              <c:numCache>
                <c:formatCode>0.00</c:formatCode>
                <c:ptCount val="8"/>
                <c:pt idx="0">
                  <c:v>400</c:v>
                </c:pt>
                <c:pt idx="1">
                  <c:v>316.12903225806457</c:v>
                </c:pt>
                <c:pt idx="2">
                  <c:v>419.35483870967744</c:v>
                </c:pt>
                <c:pt idx="3">
                  <c:v>438.70967741935488</c:v>
                </c:pt>
                <c:pt idx="4">
                  <c:v>509.67741935483872</c:v>
                </c:pt>
                <c:pt idx="5">
                  <c:v>522.58064516129036</c:v>
                </c:pt>
                <c:pt idx="6">
                  <c:v>348.38709677419354</c:v>
                </c:pt>
                <c:pt idx="7">
                  <c:v>264.516129032258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DF7-4A5D-ABEC-47CC55465543}"/>
            </c:ext>
          </c:extLst>
        </c:ser>
        <c:ser>
          <c:idx val="3"/>
          <c:order val="3"/>
          <c:tx>
            <c:strRef>
              <c:f>Sheet4!$O$30</c:f>
              <c:strCache>
                <c:ptCount val="1"/>
                <c:pt idx="0">
                  <c:v>DSA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  <a:sp3d/>
          </c:spPr>
          <c:invertIfNegative val="0"/>
          <c:cat>
            <c:strRef>
              <c:f>Sheet4!$P$26:$W$26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4!$P$30:$W$30</c:f>
              <c:numCache>
                <c:formatCode>0.00</c:formatCode>
                <c:ptCount val="8"/>
                <c:pt idx="0">
                  <c:v>625.80645161290329</c:v>
                </c:pt>
                <c:pt idx="1">
                  <c:v>290.32258064516128</c:v>
                </c:pt>
                <c:pt idx="2">
                  <c:v>322.58064516129031</c:v>
                </c:pt>
                <c:pt idx="3">
                  <c:v>541.9354838709678</c:v>
                </c:pt>
                <c:pt idx="4">
                  <c:v>587.09677419354841</c:v>
                </c:pt>
                <c:pt idx="5">
                  <c:v>535.48387096774195</c:v>
                </c:pt>
                <c:pt idx="6">
                  <c:v>606.45161290322574</c:v>
                </c:pt>
                <c:pt idx="7">
                  <c:v>445.161290322580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CDF7-4A5D-ABEC-47CC5546554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670881456"/>
        <c:axId val="670876776"/>
        <c:axId val="0"/>
      </c:bar3DChart>
      <c:catAx>
        <c:axId val="6708814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5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670876776"/>
        <c:crosses val="autoZero"/>
        <c:auto val="1"/>
        <c:lblAlgn val="ctr"/>
        <c:lblOffset val="100"/>
        <c:noMultiLvlLbl val="0"/>
      </c:catAx>
      <c:valAx>
        <c:axId val="670876776"/>
        <c:scaling>
          <c:orientation val="minMax"/>
        </c:scaling>
        <c:delete val="0"/>
        <c:axPos val="l"/>
        <c:numFmt formatCode="0" sourceLinked="0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5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7088145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55824868766404201"/>
          <c:y val="9.7845581802274692E-2"/>
          <c:w val="0.29461351706036748"/>
          <c:h val="7.345071449402157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b="1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L</a:t>
            </a:r>
          </a:p>
        </c:rich>
      </c:tx>
      <c:layout>
        <c:manualLayout>
          <c:xMode val="edge"/>
          <c:yMode val="edge"/>
          <c:x val="0.11034011373578302"/>
          <c:y val="4.166666666666666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view3D>
      <c:rotX val="15"/>
      <c:rotY val="20"/>
      <c:depthPercent val="100"/>
      <c:rAngAx val="1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>
        <c:manualLayout>
          <c:layoutTarget val="inner"/>
          <c:xMode val="edge"/>
          <c:yMode val="edge"/>
          <c:x val="7.6821741032370952E-2"/>
          <c:y val="0.13009259259259259"/>
          <c:w val="0.8926227034120735"/>
          <c:h val="0.6795042286380869"/>
        </c:manualLayout>
      </c:layout>
      <c:bar3DChart>
        <c:barDir val="col"/>
        <c:grouping val="clustered"/>
        <c:varyColors val="0"/>
        <c:ser>
          <c:idx val="0"/>
          <c:order val="0"/>
          <c:tx>
            <c:strRef>
              <c:f>mean!$J$3</c:f>
              <c:strCache>
                <c:ptCount val="1"/>
                <c:pt idx="0">
                  <c:v>NI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  <a:sp3d/>
          </c:spPr>
          <c:invertIfNegative val="0"/>
          <c:cat>
            <c:strRef>
              <c:f>mean!$K$2:$R$2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mean!$K$3:$R$3</c:f>
              <c:numCache>
                <c:formatCode>0.00</c:formatCode>
                <c:ptCount val="8"/>
                <c:pt idx="0">
                  <c:v>59.44444444444445</c:v>
                </c:pt>
                <c:pt idx="1">
                  <c:v>61.413270855995314</c:v>
                </c:pt>
                <c:pt idx="2">
                  <c:v>94.469696969696983</c:v>
                </c:pt>
                <c:pt idx="3">
                  <c:v>80.158730158730165</c:v>
                </c:pt>
                <c:pt idx="4">
                  <c:v>53.44202898550725</c:v>
                </c:pt>
                <c:pt idx="5">
                  <c:v>80.238095238095241</c:v>
                </c:pt>
                <c:pt idx="6">
                  <c:v>86.851851851851848</c:v>
                </c:pt>
                <c:pt idx="7">
                  <c:v>88.1825193845654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973-43C9-92E3-0C0998D866D3}"/>
            </c:ext>
          </c:extLst>
        </c:ser>
        <c:ser>
          <c:idx val="1"/>
          <c:order val="1"/>
          <c:tx>
            <c:strRef>
              <c:f>mean!$J$4</c:f>
              <c:strCache>
                <c:ptCount val="1"/>
                <c:pt idx="0">
                  <c:v>D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  <a:sp3d/>
          </c:spPr>
          <c:invertIfNegative val="0"/>
          <c:cat>
            <c:strRef>
              <c:f>mean!$K$2:$R$2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mean!$K$4:$R$4</c:f>
              <c:numCache>
                <c:formatCode>0.00</c:formatCode>
                <c:ptCount val="8"/>
                <c:pt idx="0">
                  <c:v>71.664448829134741</c:v>
                </c:pt>
                <c:pt idx="1">
                  <c:v>51.111111111111114</c:v>
                </c:pt>
                <c:pt idx="2">
                  <c:v>45.607553366174052</c:v>
                </c:pt>
                <c:pt idx="3">
                  <c:v>76.283846872082151</c:v>
                </c:pt>
                <c:pt idx="4">
                  <c:v>75</c:v>
                </c:pt>
                <c:pt idx="5">
                  <c:v>84.747474747474755</c:v>
                </c:pt>
                <c:pt idx="6">
                  <c:v>87.649572649572647</c:v>
                </c:pt>
                <c:pt idx="7">
                  <c:v>83.52826510721247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973-43C9-92E3-0C0998D866D3}"/>
            </c:ext>
          </c:extLst>
        </c:ser>
        <c:ser>
          <c:idx val="2"/>
          <c:order val="2"/>
          <c:tx>
            <c:strRef>
              <c:f>mean!$J$5</c:f>
              <c:strCache>
                <c:ptCount val="1"/>
                <c:pt idx="0">
                  <c:v>NSA</c:v>
                </c:pt>
              </c:strCache>
            </c:strRef>
          </c:tx>
          <c:spPr>
            <a:solidFill>
              <a:srgbClr val="002060"/>
            </a:solidFill>
            <a:ln>
              <a:noFill/>
            </a:ln>
            <a:effectLst/>
            <a:sp3d/>
          </c:spPr>
          <c:invertIfNegative val="0"/>
          <c:cat>
            <c:strRef>
              <c:f>mean!$K$2:$R$2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mean!$K$5:$R$5</c:f>
              <c:numCache>
                <c:formatCode>0.00</c:formatCode>
                <c:ptCount val="8"/>
                <c:pt idx="0">
                  <c:v>58.582621082621081</c:v>
                </c:pt>
                <c:pt idx="1">
                  <c:v>83.420289855072454</c:v>
                </c:pt>
                <c:pt idx="2">
                  <c:v>87.787524366471743</c:v>
                </c:pt>
                <c:pt idx="3">
                  <c:v>57.870370370370374</c:v>
                </c:pt>
                <c:pt idx="4">
                  <c:v>75.60277699596584</c:v>
                </c:pt>
                <c:pt idx="5">
                  <c:v>88.201058201058217</c:v>
                </c:pt>
                <c:pt idx="6">
                  <c:v>82.863247863247864</c:v>
                </c:pt>
                <c:pt idx="7">
                  <c:v>64.3104056437389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973-43C9-92E3-0C0998D866D3}"/>
            </c:ext>
          </c:extLst>
        </c:ser>
        <c:ser>
          <c:idx val="3"/>
          <c:order val="3"/>
          <c:tx>
            <c:strRef>
              <c:f>mean!$J$6</c:f>
              <c:strCache>
                <c:ptCount val="1"/>
                <c:pt idx="0">
                  <c:v>DSA</c:v>
                </c:pt>
              </c:strCache>
            </c:strRef>
          </c:tx>
          <c:spPr>
            <a:solidFill>
              <a:srgbClr val="00B0F0"/>
            </a:solidFill>
            <a:ln>
              <a:noFill/>
            </a:ln>
            <a:effectLst/>
            <a:sp3d/>
          </c:spPr>
          <c:invertIfNegative val="0"/>
          <c:cat>
            <c:strRef>
              <c:f>mean!$K$2:$R$2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mean!$K$6:$R$6</c:f>
              <c:numCache>
                <c:formatCode>0.00</c:formatCode>
                <c:ptCount val="8"/>
                <c:pt idx="0">
                  <c:v>78.948070607553362</c:v>
                </c:pt>
                <c:pt idx="1">
                  <c:v>44.848863873254118</c:v>
                </c:pt>
                <c:pt idx="2">
                  <c:v>82.839830084957512</c:v>
                </c:pt>
                <c:pt idx="3">
                  <c:v>88.612484929012567</c:v>
                </c:pt>
                <c:pt idx="4">
                  <c:v>73.341473341473332</c:v>
                </c:pt>
                <c:pt idx="5">
                  <c:v>89.317042606516296</c:v>
                </c:pt>
                <c:pt idx="6">
                  <c:v>61.777192211974828</c:v>
                </c:pt>
                <c:pt idx="7">
                  <c:v>84.0423976608187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E973-43C9-92E3-0C0998D866D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595734288"/>
        <c:axId val="399717944"/>
        <c:axId val="0"/>
      </c:bar3DChart>
      <c:catAx>
        <c:axId val="5957342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5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99717944"/>
        <c:crosses val="autoZero"/>
        <c:auto val="1"/>
        <c:lblAlgn val="ctr"/>
        <c:lblOffset val="100"/>
        <c:noMultiLvlLbl val="0"/>
      </c:catAx>
      <c:valAx>
        <c:axId val="399717944"/>
        <c:scaling>
          <c:orientation val="minMax"/>
        </c:scaling>
        <c:delete val="0"/>
        <c:axPos val="l"/>
        <c:numFmt formatCode="0" sourceLinked="0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9573428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55547090988626413"/>
          <c:y val="8.3956692913385797E-2"/>
          <c:w val="0.29461351706036748"/>
          <c:h val="7.345071449402157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b="1" dirty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C</a:t>
            </a:r>
          </a:p>
        </c:rich>
      </c:tx>
      <c:layout>
        <c:manualLayout>
          <c:xMode val="edge"/>
          <c:yMode val="edge"/>
          <c:x val="0.10736543668159451"/>
          <c:y val="6.481481481481481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view3D>
      <c:rotX val="15"/>
      <c:rotY val="20"/>
      <c:depthPercent val="100"/>
      <c:rAngAx val="1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>
        <c:manualLayout>
          <c:layoutTarget val="inner"/>
          <c:xMode val="edge"/>
          <c:yMode val="edge"/>
          <c:x val="7.387841869560581E-2"/>
          <c:y val="0.19027777777777777"/>
          <c:w val="0.90361786031067748"/>
          <c:h val="0.6702449693788276"/>
        </c:manualLayout>
      </c:layout>
      <c:bar3DChart>
        <c:barDir val="col"/>
        <c:grouping val="clustered"/>
        <c:varyColors val="0"/>
        <c:ser>
          <c:idx val="0"/>
          <c:order val="0"/>
          <c:tx>
            <c:strRef>
              <c:f>mean!$I$4</c:f>
              <c:strCache>
                <c:ptCount val="1"/>
                <c:pt idx="0">
                  <c:v>NI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  <a:sp3d/>
          </c:spPr>
          <c:invertIfNegative val="0"/>
          <c:cat>
            <c:strRef>
              <c:f>mean!$J$3:$Q$3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mean!$J$4:$Q$4</c:f>
              <c:numCache>
                <c:formatCode>0.00</c:formatCode>
                <c:ptCount val="8"/>
                <c:pt idx="0">
                  <c:v>92.054037707197764</c:v>
                </c:pt>
                <c:pt idx="1">
                  <c:v>91.657404189446268</c:v>
                </c:pt>
                <c:pt idx="2">
                  <c:v>87.799739369228803</c:v>
                </c:pt>
                <c:pt idx="3">
                  <c:v>90.119006388055098</c:v>
                </c:pt>
                <c:pt idx="4">
                  <c:v>86.15263972541436</c:v>
                </c:pt>
                <c:pt idx="5">
                  <c:v>90.329185299678855</c:v>
                </c:pt>
                <c:pt idx="6">
                  <c:v>89.079259225695736</c:v>
                </c:pt>
                <c:pt idx="7">
                  <c:v>86.04960201882174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9A0-4471-A732-83016356D1A1}"/>
            </c:ext>
          </c:extLst>
        </c:ser>
        <c:ser>
          <c:idx val="1"/>
          <c:order val="1"/>
          <c:tx>
            <c:strRef>
              <c:f>mean!$I$5</c:f>
              <c:strCache>
                <c:ptCount val="1"/>
                <c:pt idx="0">
                  <c:v>D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  <a:sp3d/>
          </c:spPr>
          <c:invertIfNegative val="0"/>
          <c:cat>
            <c:strRef>
              <c:f>mean!$J$3:$Q$3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mean!$J$5:$Q$5</c:f>
              <c:numCache>
                <c:formatCode>0.00</c:formatCode>
                <c:ptCount val="8"/>
                <c:pt idx="0">
                  <c:v>85.907413149075012</c:v>
                </c:pt>
                <c:pt idx="1">
                  <c:v>87.538608489625105</c:v>
                </c:pt>
                <c:pt idx="2">
                  <c:v>87.569806685755395</c:v>
                </c:pt>
                <c:pt idx="3">
                  <c:v>83.308530384155645</c:v>
                </c:pt>
                <c:pt idx="4">
                  <c:v>82.361784763029988</c:v>
                </c:pt>
                <c:pt idx="5">
                  <c:v>86.504828155771563</c:v>
                </c:pt>
                <c:pt idx="6">
                  <c:v>79.15642444028137</c:v>
                </c:pt>
                <c:pt idx="7">
                  <c:v>83.8062371829579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9A0-4471-A732-83016356D1A1}"/>
            </c:ext>
          </c:extLst>
        </c:ser>
        <c:ser>
          <c:idx val="2"/>
          <c:order val="2"/>
          <c:tx>
            <c:strRef>
              <c:f>mean!$I$6</c:f>
              <c:strCache>
                <c:ptCount val="1"/>
                <c:pt idx="0">
                  <c:v>NSA</c:v>
                </c:pt>
              </c:strCache>
            </c:strRef>
          </c:tx>
          <c:spPr>
            <a:solidFill>
              <a:srgbClr val="002060"/>
            </a:solidFill>
            <a:ln>
              <a:noFill/>
            </a:ln>
            <a:effectLst/>
            <a:sp3d/>
          </c:spPr>
          <c:invertIfNegative val="0"/>
          <c:cat>
            <c:strRef>
              <c:f>mean!$J$3:$Q$3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mean!$J$6:$Q$6</c:f>
              <c:numCache>
                <c:formatCode>0.00</c:formatCode>
                <c:ptCount val="8"/>
                <c:pt idx="0">
                  <c:v>88.277256715301476</c:v>
                </c:pt>
                <c:pt idx="1">
                  <c:v>90.908274909131634</c:v>
                </c:pt>
                <c:pt idx="2">
                  <c:v>88.503780555080255</c:v>
                </c:pt>
                <c:pt idx="3">
                  <c:v>79.742796984176309</c:v>
                </c:pt>
                <c:pt idx="4">
                  <c:v>86.502077131088683</c:v>
                </c:pt>
                <c:pt idx="5">
                  <c:v>90.075825481570917</c:v>
                </c:pt>
                <c:pt idx="6">
                  <c:v>90.693356296401817</c:v>
                </c:pt>
                <c:pt idx="7">
                  <c:v>89.7623522042126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9A0-4471-A732-83016356D1A1}"/>
            </c:ext>
          </c:extLst>
        </c:ser>
        <c:ser>
          <c:idx val="3"/>
          <c:order val="3"/>
          <c:tx>
            <c:strRef>
              <c:f>mean!$I$7</c:f>
              <c:strCache>
                <c:ptCount val="1"/>
                <c:pt idx="0">
                  <c:v>DSA</c:v>
                </c:pt>
              </c:strCache>
            </c:strRef>
          </c:tx>
          <c:spPr>
            <a:solidFill>
              <a:srgbClr val="00B0F0"/>
            </a:solidFill>
            <a:ln>
              <a:noFill/>
            </a:ln>
            <a:effectLst/>
            <a:sp3d/>
          </c:spPr>
          <c:invertIfNegative val="0"/>
          <c:cat>
            <c:strRef>
              <c:f>mean!$J$3:$Q$3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mean!$J$7:$Q$7</c:f>
              <c:numCache>
                <c:formatCode>0.00</c:formatCode>
                <c:ptCount val="8"/>
                <c:pt idx="0">
                  <c:v>85.75885928972518</c:v>
                </c:pt>
                <c:pt idx="1">
                  <c:v>86.346963537713307</c:v>
                </c:pt>
                <c:pt idx="2">
                  <c:v>87.012300130637399</c:v>
                </c:pt>
                <c:pt idx="3">
                  <c:v>82.292043027174316</c:v>
                </c:pt>
                <c:pt idx="4">
                  <c:v>86.796536796536785</c:v>
                </c:pt>
                <c:pt idx="5">
                  <c:v>82.216934242736571</c:v>
                </c:pt>
                <c:pt idx="6">
                  <c:v>80.660730160073243</c:v>
                </c:pt>
                <c:pt idx="7">
                  <c:v>84.1952186313318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F9A0-4471-A732-83016356D1A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390619808"/>
        <c:axId val="390620168"/>
        <c:axId val="0"/>
      </c:bar3DChart>
      <c:catAx>
        <c:axId val="3906198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5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90620168"/>
        <c:crosses val="autoZero"/>
        <c:auto val="1"/>
        <c:lblAlgn val="ctr"/>
        <c:lblOffset val="100"/>
        <c:noMultiLvlLbl val="0"/>
      </c:catAx>
      <c:valAx>
        <c:axId val="390620168"/>
        <c:scaling>
          <c:orientation val="minMax"/>
        </c:scaling>
        <c:delete val="0"/>
        <c:axPos val="l"/>
        <c:numFmt formatCode="0" sourceLinked="0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906198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5626634220737784"/>
          <c:y val="4.2244823563721209E-2"/>
          <c:w val="0.29461351706036748"/>
          <c:h val="7.345071449402157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DW</a:t>
            </a:r>
          </a:p>
        </c:rich>
      </c:tx>
      <c:layout>
        <c:manualLayout>
          <c:xMode val="edge"/>
          <c:yMode val="edge"/>
          <c:x val="5.5152354882678299E-2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view3D>
      <c:rotX val="15"/>
      <c:rotY val="20"/>
      <c:depthPercent val="100"/>
      <c:rAngAx val="1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>
        <c:manualLayout>
          <c:layoutTarget val="inner"/>
          <c:xMode val="edge"/>
          <c:yMode val="edge"/>
          <c:x val="5.6682852143482065E-2"/>
          <c:y val="0.1093700661469504"/>
          <c:w val="0.94331714785651799"/>
          <c:h val="0.64449788824099363"/>
        </c:manualLayout>
      </c:layout>
      <c:bar3DChart>
        <c:barDir val="col"/>
        <c:grouping val="clustered"/>
        <c:varyColors val="0"/>
        <c:ser>
          <c:idx val="0"/>
          <c:order val="0"/>
          <c:tx>
            <c:strRef>
              <c:f>Sheet3!$Y$29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  <a:sp3d/>
          </c:spPr>
          <c:invertIfNegative val="0"/>
          <c:cat>
            <c:strRef>
              <c:f>Sheet3!$Z$28:$AG$28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3!$Z$29:$AG$29</c:f>
              <c:numCache>
                <c:formatCode>General</c:formatCode>
                <c:ptCount val="8"/>
                <c:pt idx="0">
                  <c:v>0.48</c:v>
                </c:pt>
                <c:pt idx="1">
                  <c:v>0.61</c:v>
                </c:pt>
                <c:pt idx="2">
                  <c:v>0.71</c:v>
                </c:pt>
                <c:pt idx="3">
                  <c:v>0.28999999999999998</c:v>
                </c:pt>
                <c:pt idx="4">
                  <c:v>0.74</c:v>
                </c:pt>
                <c:pt idx="5">
                  <c:v>0.51</c:v>
                </c:pt>
                <c:pt idx="6">
                  <c:v>0.74</c:v>
                </c:pt>
                <c:pt idx="7">
                  <c:v>1.120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529-4625-9243-AA10FC89EAE1}"/>
            </c:ext>
          </c:extLst>
        </c:ser>
        <c:ser>
          <c:idx val="1"/>
          <c:order val="1"/>
          <c:tx>
            <c:strRef>
              <c:f>Sheet3!$Y$30</c:f>
              <c:strCache>
                <c:ptCount val="1"/>
                <c:pt idx="0">
                  <c:v>D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  <a:sp3d/>
          </c:spPr>
          <c:invertIfNegative val="0"/>
          <c:cat>
            <c:strRef>
              <c:f>Sheet3!$Z$28:$AG$28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3!$Z$30:$AG$30</c:f>
              <c:numCache>
                <c:formatCode>General</c:formatCode>
                <c:ptCount val="8"/>
                <c:pt idx="0">
                  <c:v>0.69</c:v>
                </c:pt>
                <c:pt idx="1">
                  <c:v>0.81</c:v>
                </c:pt>
                <c:pt idx="2">
                  <c:v>0.79</c:v>
                </c:pt>
                <c:pt idx="3">
                  <c:v>0.33</c:v>
                </c:pt>
                <c:pt idx="4">
                  <c:v>0.28000000000000003</c:v>
                </c:pt>
                <c:pt idx="5">
                  <c:v>0.45</c:v>
                </c:pt>
                <c:pt idx="6">
                  <c:v>0.38</c:v>
                </c:pt>
                <c:pt idx="7">
                  <c:v>0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529-4625-9243-AA10FC89EAE1}"/>
            </c:ext>
          </c:extLst>
        </c:ser>
        <c:ser>
          <c:idx val="2"/>
          <c:order val="2"/>
          <c:tx>
            <c:strRef>
              <c:f>Sheet3!$Y$31</c:f>
              <c:strCache>
                <c:ptCount val="1"/>
                <c:pt idx="0">
                  <c:v>NSA</c:v>
                </c:pt>
              </c:strCache>
            </c:strRef>
          </c:tx>
          <c:spPr>
            <a:solidFill>
              <a:srgbClr val="002060"/>
            </a:solidFill>
            <a:ln>
              <a:noFill/>
            </a:ln>
            <a:effectLst/>
            <a:sp3d/>
          </c:spPr>
          <c:invertIfNegative val="0"/>
          <c:cat>
            <c:strRef>
              <c:f>Sheet3!$Z$28:$AG$28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3!$Z$31:$AG$31</c:f>
              <c:numCache>
                <c:formatCode>General</c:formatCode>
                <c:ptCount val="8"/>
                <c:pt idx="0">
                  <c:v>0.69</c:v>
                </c:pt>
                <c:pt idx="1">
                  <c:v>0.89</c:v>
                </c:pt>
                <c:pt idx="2">
                  <c:v>0.74</c:v>
                </c:pt>
                <c:pt idx="3">
                  <c:v>0.47</c:v>
                </c:pt>
                <c:pt idx="4">
                  <c:v>0.66</c:v>
                </c:pt>
                <c:pt idx="5">
                  <c:v>0.57999999999999996</c:v>
                </c:pt>
                <c:pt idx="6">
                  <c:v>0.6</c:v>
                </c:pt>
                <c:pt idx="7">
                  <c:v>0.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529-4625-9243-AA10FC89EAE1}"/>
            </c:ext>
          </c:extLst>
        </c:ser>
        <c:ser>
          <c:idx val="3"/>
          <c:order val="3"/>
          <c:tx>
            <c:strRef>
              <c:f>Sheet3!$Y$32</c:f>
              <c:strCache>
                <c:ptCount val="1"/>
                <c:pt idx="0">
                  <c:v>DSA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  <a:sp3d/>
          </c:spPr>
          <c:invertIfNegative val="0"/>
          <c:cat>
            <c:strRef>
              <c:f>Sheet3!$Z$28:$AG$28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3!$Z$32:$AG$32</c:f>
              <c:numCache>
                <c:formatCode>General</c:formatCode>
                <c:ptCount val="8"/>
                <c:pt idx="0">
                  <c:v>0.87</c:v>
                </c:pt>
                <c:pt idx="1">
                  <c:v>0.87</c:v>
                </c:pt>
                <c:pt idx="2">
                  <c:v>0.75</c:v>
                </c:pt>
                <c:pt idx="3">
                  <c:v>0.28000000000000003</c:v>
                </c:pt>
                <c:pt idx="4">
                  <c:v>0.79</c:v>
                </c:pt>
                <c:pt idx="5">
                  <c:v>0.52</c:v>
                </c:pt>
                <c:pt idx="6">
                  <c:v>0.84</c:v>
                </c:pt>
                <c:pt idx="7">
                  <c:v>0.4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7529-4625-9243-AA10FC89EAE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769430960"/>
        <c:axId val="769432040"/>
        <c:axId val="0"/>
      </c:bar3DChart>
      <c:catAx>
        <c:axId val="7694309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769432040"/>
        <c:crosses val="autoZero"/>
        <c:auto val="1"/>
        <c:lblAlgn val="ctr"/>
        <c:lblOffset val="100"/>
        <c:noMultiLvlLbl val="0"/>
      </c:catAx>
      <c:valAx>
        <c:axId val="76943204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76943096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59257904993635457"/>
          <c:y val="5.844515335556992E-2"/>
          <c:w val="0.27754182652018711"/>
          <c:h val="7.511666028547238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 b="1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b="1" dirty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W</a:t>
            </a:r>
          </a:p>
        </c:rich>
      </c:tx>
      <c:layout>
        <c:manualLayout>
          <c:xMode val="edge"/>
          <c:yMode val="edge"/>
          <c:x val="0"/>
          <c:y val="8.7745681249314089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view3D>
      <c:rotX val="15"/>
      <c:rotY val="20"/>
      <c:depthPercent val="100"/>
      <c:rAngAx val="1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>
        <c:manualLayout>
          <c:layoutTarget val="inner"/>
          <c:xMode val="edge"/>
          <c:yMode val="edge"/>
          <c:x val="7.6658124004657199E-2"/>
          <c:y val="9.332316026984179E-2"/>
          <c:w val="0.87637507862371689"/>
          <c:h val="0.62963514997920023"/>
        </c:manualLayout>
      </c:layout>
      <c:bar3DChart>
        <c:barDir val="col"/>
        <c:grouping val="clustered"/>
        <c:varyColors val="0"/>
        <c:ser>
          <c:idx val="0"/>
          <c:order val="0"/>
          <c:tx>
            <c:strRef>
              <c:f>Sheet3!$Y$24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  <a:sp3d/>
          </c:spPr>
          <c:invertIfNegative val="0"/>
          <c:cat>
            <c:strRef>
              <c:f>Sheet3!$Z$23:$AG$23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3!$Z$24:$AG$24</c:f>
              <c:numCache>
                <c:formatCode>General</c:formatCode>
                <c:ptCount val="8"/>
                <c:pt idx="0">
                  <c:v>9.2200000000000006</c:v>
                </c:pt>
                <c:pt idx="1">
                  <c:v>7.57</c:v>
                </c:pt>
                <c:pt idx="2">
                  <c:v>6.42</c:v>
                </c:pt>
                <c:pt idx="3">
                  <c:v>3.66</c:v>
                </c:pt>
                <c:pt idx="4">
                  <c:v>4.8499999999999996</c:v>
                </c:pt>
                <c:pt idx="5">
                  <c:v>4.16</c:v>
                </c:pt>
                <c:pt idx="6">
                  <c:v>5.45</c:v>
                </c:pt>
                <c:pt idx="7">
                  <c:v>8.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F1D-45FE-A554-B2BB3CB09775}"/>
            </c:ext>
          </c:extLst>
        </c:ser>
        <c:ser>
          <c:idx val="1"/>
          <c:order val="1"/>
          <c:tx>
            <c:strRef>
              <c:f>Sheet3!$Y$25</c:f>
              <c:strCache>
                <c:ptCount val="1"/>
                <c:pt idx="0">
                  <c:v>D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  <a:sp3d/>
          </c:spPr>
          <c:invertIfNegative val="0"/>
          <c:cat>
            <c:strRef>
              <c:f>Sheet3!$Z$23:$AG$23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3!$Z$25:$AG$25</c:f>
              <c:numCache>
                <c:formatCode>General</c:formatCode>
                <c:ptCount val="8"/>
                <c:pt idx="0">
                  <c:v>3.88</c:v>
                </c:pt>
                <c:pt idx="1">
                  <c:v>7.1</c:v>
                </c:pt>
                <c:pt idx="2">
                  <c:v>5.55</c:v>
                </c:pt>
                <c:pt idx="3">
                  <c:v>1.42</c:v>
                </c:pt>
                <c:pt idx="4">
                  <c:v>2.4500000000000002</c:v>
                </c:pt>
                <c:pt idx="5">
                  <c:v>3.3</c:v>
                </c:pt>
                <c:pt idx="6">
                  <c:v>2.0099999999999998</c:v>
                </c:pt>
                <c:pt idx="7">
                  <c:v>2.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F1D-45FE-A554-B2BB3CB09775}"/>
            </c:ext>
          </c:extLst>
        </c:ser>
        <c:ser>
          <c:idx val="2"/>
          <c:order val="2"/>
          <c:tx>
            <c:strRef>
              <c:f>Sheet3!$Y$26</c:f>
              <c:strCache>
                <c:ptCount val="1"/>
                <c:pt idx="0">
                  <c:v>NSA</c:v>
                </c:pt>
              </c:strCache>
            </c:strRef>
          </c:tx>
          <c:spPr>
            <a:solidFill>
              <a:srgbClr val="002060"/>
            </a:solidFill>
            <a:ln>
              <a:noFill/>
            </a:ln>
            <a:effectLst/>
            <a:sp3d/>
          </c:spPr>
          <c:invertIfNegative val="0"/>
          <c:cat>
            <c:strRef>
              <c:f>Sheet3!$Z$23:$AG$23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3!$Z$26:$AG$26</c:f>
              <c:numCache>
                <c:formatCode>General</c:formatCode>
                <c:ptCount val="8"/>
                <c:pt idx="0">
                  <c:v>7.16</c:v>
                </c:pt>
                <c:pt idx="1">
                  <c:v>7.43</c:v>
                </c:pt>
                <c:pt idx="2">
                  <c:v>7.33</c:v>
                </c:pt>
                <c:pt idx="3">
                  <c:v>2.2200000000000002</c:v>
                </c:pt>
                <c:pt idx="4">
                  <c:v>5.13</c:v>
                </c:pt>
                <c:pt idx="5">
                  <c:v>5.32</c:v>
                </c:pt>
                <c:pt idx="6">
                  <c:v>6.95</c:v>
                </c:pt>
                <c:pt idx="7">
                  <c:v>6.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F1D-45FE-A554-B2BB3CB09775}"/>
            </c:ext>
          </c:extLst>
        </c:ser>
        <c:ser>
          <c:idx val="3"/>
          <c:order val="3"/>
          <c:tx>
            <c:strRef>
              <c:f>Sheet3!$Y$27</c:f>
              <c:strCache>
                <c:ptCount val="1"/>
                <c:pt idx="0">
                  <c:v>DSA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  <a:sp3d/>
          </c:spPr>
          <c:invertIfNegative val="0"/>
          <c:cat>
            <c:strRef>
              <c:f>Sheet3!$Z$23:$AG$23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3!$Z$27:$AG$27</c:f>
              <c:numCache>
                <c:formatCode>General</c:formatCode>
                <c:ptCount val="8"/>
                <c:pt idx="0">
                  <c:v>5.8</c:v>
                </c:pt>
                <c:pt idx="1">
                  <c:v>6.84</c:v>
                </c:pt>
                <c:pt idx="2">
                  <c:v>5.58</c:v>
                </c:pt>
                <c:pt idx="3">
                  <c:v>1.94</c:v>
                </c:pt>
                <c:pt idx="4">
                  <c:v>4.53</c:v>
                </c:pt>
                <c:pt idx="5">
                  <c:v>4.29</c:v>
                </c:pt>
                <c:pt idx="6">
                  <c:v>4.28</c:v>
                </c:pt>
                <c:pt idx="7">
                  <c:v>3.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1F1D-45FE-A554-B2BB3CB0977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592932392"/>
        <c:axId val="592931672"/>
        <c:axId val="0"/>
      </c:bar3DChart>
      <c:catAx>
        <c:axId val="5929323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5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92931672"/>
        <c:crosses val="autoZero"/>
        <c:auto val="1"/>
        <c:lblAlgn val="ctr"/>
        <c:lblOffset val="100"/>
        <c:noMultiLvlLbl val="0"/>
      </c:catAx>
      <c:valAx>
        <c:axId val="59293167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9293239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58889707456095897"/>
          <c:y val="0.10447410128751519"/>
          <c:w val="0.29144739954715959"/>
          <c:h val="7.522732660920730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b="1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L</a:t>
            </a:r>
          </a:p>
        </c:rich>
      </c:tx>
      <c:layout>
        <c:manualLayout>
          <c:xMode val="edge"/>
          <c:yMode val="edge"/>
          <c:x val="3.0651662104468701E-2"/>
          <c:y val="1.851851851851851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view3D>
      <c:rotX val="15"/>
      <c:rotY val="20"/>
      <c:depthPercent val="100"/>
      <c:rAngAx val="1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>
        <c:manualLayout>
          <c:layoutTarget val="inner"/>
          <c:xMode val="edge"/>
          <c:yMode val="edge"/>
          <c:x val="7.7247337494686791E-2"/>
          <c:y val="0.12744713974530758"/>
          <c:w val="0.88950283174068434"/>
          <c:h val="0.59415427679153221"/>
        </c:manualLayout>
      </c:layout>
      <c:bar3DChart>
        <c:barDir val="col"/>
        <c:grouping val="clustered"/>
        <c:varyColors val="0"/>
        <c:ser>
          <c:idx val="0"/>
          <c:order val="0"/>
          <c:tx>
            <c:strRef>
              <c:f>Sheet3!$Y$39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  <a:sp3d/>
          </c:spPr>
          <c:invertIfNegative val="0"/>
          <c:cat>
            <c:strRef>
              <c:f>Sheet3!$Z$38:$AG$38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3!$Z$39:$AG$39</c:f>
              <c:numCache>
                <c:formatCode>General</c:formatCode>
                <c:ptCount val="8"/>
                <c:pt idx="0">
                  <c:v>7.1509999999999998</c:v>
                </c:pt>
                <c:pt idx="1">
                  <c:v>7.0060000000000002</c:v>
                </c:pt>
                <c:pt idx="2">
                  <c:v>7.2910000000000004</c:v>
                </c:pt>
                <c:pt idx="3">
                  <c:v>6.9560000000000004</c:v>
                </c:pt>
                <c:pt idx="4">
                  <c:v>10.563000000000001</c:v>
                </c:pt>
                <c:pt idx="5">
                  <c:v>8.3670000000000009</c:v>
                </c:pt>
                <c:pt idx="6">
                  <c:v>7.101</c:v>
                </c:pt>
                <c:pt idx="7">
                  <c:v>6.447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4AE-4F9A-BB7B-99481D496C1F}"/>
            </c:ext>
          </c:extLst>
        </c:ser>
        <c:ser>
          <c:idx val="1"/>
          <c:order val="1"/>
          <c:tx>
            <c:strRef>
              <c:f>Sheet3!$Y$40</c:f>
              <c:strCache>
                <c:ptCount val="1"/>
                <c:pt idx="0">
                  <c:v>D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  <a:sp3d/>
          </c:spPr>
          <c:invertIfNegative val="0"/>
          <c:cat>
            <c:strRef>
              <c:f>Sheet3!$Z$38:$AG$38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3!$Z$40:$AG$40</c:f>
              <c:numCache>
                <c:formatCode>General</c:formatCode>
                <c:ptCount val="8"/>
                <c:pt idx="0">
                  <c:v>6.7539999999999996</c:v>
                </c:pt>
                <c:pt idx="1">
                  <c:v>7.718</c:v>
                </c:pt>
                <c:pt idx="2">
                  <c:v>5.6230000000000002</c:v>
                </c:pt>
                <c:pt idx="3">
                  <c:v>6.5960000000000001</c:v>
                </c:pt>
                <c:pt idx="4">
                  <c:v>5.9740000000000002</c:v>
                </c:pt>
                <c:pt idx="5">
                  <c:v>7.8319999999999999</c:v>
                </c:pt>
                <c:pt idx="6">
                  <c:v>7.1989999999999998</c:v>
                </c:pt>
                <c:pt idx="7">
                  <c:v>5.9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4AE-4F9A-BB7B-99481D496C1F}"/>
            </c:ext>
          </c:extLst>
        </c:ser>
        <c:ser>
          <c:idx val="2"/>
          <c:order val="2"/>
          <c:tx>
            <c:strRef>
              <c:f>Sheet3!$Y$41</c:f>
              <c:strCache>
                <c:ptCount val="1"/>
                <c:pt idx="0">
                  <c:v>NSA</c:v>
                </c:pt>
              </c:strCache>
            </c:strRef>
          </c:tx>
          <c:spPr>
            <a:solidFill>
              <a:srgbClr val="002060"/>
            </a:solidFill>
            <a:ln>
              <a:noFill/>
            </a:ln>
            <a:effectLst/>
            <a:sp3d/>
          </c:spPr>
          <c:invertIfNegative val="0"/>
          <c:cat>
            <c:strRef>
              <c:f>Sheet3!$Z$38:$AG$38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3!$Z$41:$AG$41</c:f>
              <c:numCache>
                <c:formatCode>General</c:formatCode>
                <c:ptCount val="8"/>
                <c:pt idx="0">
                  <c:v>13.358000000000001</c:v>
                </c:pt>
                <c:pt idx="1">
                  <c:v>6.5940000000000003</c:v>
                </c:pt>
                <c:pt idx="2">
                  <c:v>6.9530000000000003</c:v>
                </c:pt>
                <c:pt idx="3">
                  <c:v>7.6050000000000004</c:v>
                </c:pt>
                <c:pt idx="4">
                  <c:v>7.742</c:v>
                </c:pt>
                <c:pt idx="5">
                  <c:v>8.7629999999999999</c:v>
                </c:pt>
                <c:pt idx="6">
                  <c:v>6.694</c:v>
                </c:pt>
                <c:pt idx="7">
                  <c:v>7.113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4AE-4F9A-BB7B-99481D496C1F}"/>
            </c:ext>
          </c:extLst>
        </c:ser>
        <c:ser>
          <c:idx val="3"/>
          <c:order val="3"/>
          <c:tx>
            <c:strRef>
              <c:f>Sheet3!$Y$42</c:f>
              <c:strCache>
                <c:ptCount val="1"/>
                <c:pt idx="0">
                  <c:v>DSA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  <a:sp3d/>
          </c:spPr>
          <c:invertIfNegative val="0"/>
          <c:cat>
            <c:strRef>
              <c:f>Sheet3!$Z$38:$AG$38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3!$Z$42:$AG$42</c:f>
              <c:numCache>
                <c:formatCode>General</c:formatCode>
                <c:ptCount val="8"/>
                <c:pt idx="0">
                  <c:v>7.0369999999999999</c:v>
                </c:pt>
                <c:pt idx="1">
                  <c:v>6.7119999999999997</c:v>
                </c:pt>
                <c:pt idx="2">
                  <c:v>8.3010000000000002</c:v>
                </c:pt>
                <c:pt idx="3">
                  <c:v>6.0880000000000001</c:v>
                </c:pt>
                <c:pt idx="4">
                  <c:v>4.6779999999999999</c:v>
                </c:pt>
                <c:pt idx="5">
                  <c:v>7.5529999999999999</c:v>
                </c:pt>
                <c:pt idx="6">
                  <c:v>7.7889999999999997</c:v>
                </c:pt>
                <c:pt idx="7">
                  <c:v>8.36999999999999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94AE-4F9A-BB7B-99481D496C1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592840592"/>
        <c:axId val="592833392"/>
        <c:axId val="0"/>
      </c:bar3DChart>
      <c:catAx>
        <c:axId val="5928405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5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92833392"/>
        <c:crosses val="autoZero"/>
        <c:auto val="1"/>
        <c:lblAlgn val="ctr"/>
        <c:lblOffset val="100"/>
        <c:noMultiLvlLbl val="0"/>
      </c:catAx>
      <c:valAx>
        <c:axId val="59283339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9284059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2519313210848648"/>
          <c:y val="9.3215952172645056E-2"/>
          <c:w val="0.28294685039370077"/>
          <c:h val="7.345071449402157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b="1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HL/RL</a:t>
            </a:r>
          </a:p>
        </c:rich>
      </c:tx>
      <c:layout>
        <c:manualLayout>
          <c:xMode val="edge"/>
          <c:yMode val="edge"/>
          <c:x val="3.4229002624671913E-2"/>
          <c:y val="8.333333333333332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view3D>
      <c:rotX val="15"/>
      <c:rotY val="20"/>
      <c:depthPercent val="100"/>
      <c:rAngAx val="1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>
        <c:manualLayout>
          <c:layoutTarget val="inner"/>
          <c:xMode val="edge"/>
          <c:yMode val="edge"/>
          <c:x val="4.4465223097112865E-2"/>
          <c:y val="0.1763888888888889"/>
          <c:w val="0.9138681102362205"/>
          <c:h val="0.66521471274424027"/>
        </c:manualLayout>
      </c:layout>
      <c:bar3DChart>
        <c:barDir val="col"/>
        <c:grouping val="clustered"/>
        <c:varyColors val="0"/>
        <c:ser>
          <c:idx val="0"/>
          <c:order val="0"/>
          <c:tx>
            <c:strRef>
              <c:f>Sheet3!$Y$44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  <a:sp3d/>
          </c:spPr>
          <c:invertIfNegative val="0"/>
          <c:cat>
            <c:strRef>
              <c:f>Sheet3!$Z$43:$AG$43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3!$Z$44:$AG$44</c:f>
              <c:numCache>
                <c:formatCode>0.00</c:formatCode>
                <c:ptCount val="8"/>
                <c:pt idx="0">
                  <c:v>6.5313942105999168</c:v>
                </c:pt>
                <c:pt idx="1">
                  <c:v>7.380388238652583</c:v>
                </c:pt>
                <c:pt idx="2">
                  <c:v>5.4853929502125904</c:v>
                </c:pt>
                <c:pt idx="3">
                  <c:v>5.4189189189189193</c:v>
                </c:pt>
                <c:pt idx="4">
                  <c:v>3.7452428287418345</c:v>
                </c:pt>
                <c:pt idx="5">
                  <c:v>4.8261025457153099</c:v>
                </c:pt>
                <c:pt idx="6">
                  <c:v>6.3660047880580199</c:v>
                </c:pt>
                <c:pt idx="7">
                  <c:v>8.05459903831239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CA2-4FBA-85BC-F5344E158A2B}"/>
            </c:ext>
          </c:extLst>
        </c:ser>
        <c:ser>
          <c:idx val="1"/>
          <c:order val="1"/>
          <c:tx>
            <c:strRef>
              <c:f>Sheet3!$Y$45</c:f>
              <c:strCache>
                <c:ptCount val="1"/>
                <c:pt idx="0">
                  <c:v>D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  <a:sp3d/>
          </c:spPr>
          <c:invertIfNegative val="0"/>
          <c:cat>
            <c:strRef>
              <c:f>Sheet3!$Z$43:$AG$43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3!$Z$45:$AG$45</c:f>
              <c:numCache>
                <c:formatCode>0.00</c:formatCode>
                <c:ptCount val="8"/>
                <c:pt idx="0">
                  <c:v>3.7265459891574015</c:v>
                </c:pt>
                <c:pt idx="1">
                  <c:v>4.5003870396992154</c:v>
                </c:pt>
                <c:pt idx="2">
                  <c:v>6.753882267966774</c:v>
                </c:pt>
                <c:pt idx="3">
                  <c:v>4.3992124984122949</c:v>
                </c:pt>
                <c:pt idx="4">
                  <c:v>5.1339285714285712</c:v>
                </c:pt>
                <c:pt idx="5">
                  <c:v>6.2750862663906144</c:v>
                </c:pt>
                <c:pt idx="6">
                  <c:v>5.8297169133496203</c:v>
                </c:pt>
                <c:pt idx="7">
                  <c:v>6.210069444444444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CA2-4FBA-85BC-F5344E158A2B}"/>
            </c:ext>
          </c:extLst>
        </c:ser>
        <c:ser>
          <c:idx val="2"/>
          <c:order val="2"/>
          <c:tx>
            <c:strRef>
              <c:f>Sheet3!$Y$46</c:f>
              <c:strCache>
                <c:ptCount val="1"/>
                <c:pt idx="0">
                  <c:v>NSA</c:v>
                </c:pt>
              </c:strCache>
            </c:strRef>
          </c:tx>
          <c:spPr>
            <a:solidFill>
              <a:srgbClr val="002060"/>
            </a:solidFill>
            <a:ln>
              <a:noFill/>
            </a:ln>
            <a:effectLst/>
            <a:sp3d/>
          </c:spPr>
          <c:invertIfNegative val="0"/>
          <c:cat>
            <c:strRef>
              <c:f>Sheet3!$Z$43:$AG$43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3!$Z$46:$AG$46</c:f>
              <c:numCache>
                <c:formatCode>0.00</c:formatCode>
                <c:ptCount val="8"/>
                <c:pt idx="0">
                  <c:v>3.4765927763137499</c:v>
                </c:pt>
                <c:pt idx="1">
                  <c:v>6.8055518304948377</c:v>
                </c:pt>
                <c:pt idx="2">
                  <c:v>6.9222674813306178</c:v>
                </c:pt>
                <c:pt idx="3">
                  <c:v>4.0821719255212399</c:v>
                </c:pt>
                <c:pt idx="4">
                  <c:v>4.970472190403461</c:v>
                </c:pt>
                <c:pt idx="5">
                  <c:v>3.6742616033755278</c:v>
                </c:pt>
                <c:pt idx="6">
                  <c:v>6.3497703323426098</c:v>
                </c:pt>
                <c:pt idx="7">
                  <c:v>5.01994236311239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CA2-4FBA-85BC-F5344E158A2B}"/>
            </c:ext>
          </c:extLst>
        </c:ser>
        <c:ser>
          <c:idx val="3"/>
          <c:order val="3"/>
          <c:tx>
            <c:strRef>
              <c:f>Sheet3!$Y$47</c:f>
              <c:strCache>
                <c:ptCount val="1"/>
                <c:pt idx="0">
                  <c:v>DSA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  <a:sp3d/>
          </c:spPr>
          <c:invertIfNegative val="0"/>
          <c:cat>
            <c:strRef>
              <c:f>Sheet3!$Z$43:$AG$43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3!$Z$47:$AG$47</c:f>
              <c:numCache>
                <c:formatCode>0.00</c:formatCode>
                <c:ptCount val="8"/>
                <c:pt idx="0">
                  <c:v>5.494182924646501</c:v>
                </c:pt>
                <c:pt idx="1">
                  <c:v>6.5150392017106205</c:v>
                </c:pt>
                <c:pt idx="2">
                  <c:v>5.3864577173270245</c:v>
                </c:pt>
                <c:pt idx="3">
                  <c:v>5.9291523087525846</c:v>
                </c:pt>
                <c:pt idx="4">
                  <c:v>4.4717413972888425</c:v>
                </c:pt>
                <c:pt idx="5">
                  <c:v>8.0579950289975155</c:v>
                </c:pt>
                <c:pt idx="6">
                  <c:v>5.4980336636778357</c:v>
                </c:pt>
                <c:pt idx="7">
                  <c:v>6.37201420271142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CA2-4FBA-85BC-F5344E158A2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769392456"/>
        <c:axId val="735327696"/>
        <c:axId val="0"/>
      </c:bar3DChart>
      <c:catAx>
        <c:axId val="7693924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5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735327696"/>
        <c:crosses val="autoZero"/>
        <c:auto val="1"/>
        <c:lblAlgn val="ctr"/>
        <c:lblOffset val="100"/>
        <c:noMultiLvlLbl val="0"/>
      </c:catAx>
      <c:valAx>
        <c:axId val="735327696"/>
        <c:scaling>
          <c:orientation val="minMax"/>
        </c:scaling>
        <c:delete val="0"/>
        <c:axPos val="l"/>
        <c:numFmt formatCode="0" sourceLinked="0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76939245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140820209973753"/>
          <c:y val="0.1256233595800525"/>
          <c:w val="0.28294685039370077"/>
          <c:h val="7.345071449402157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b="1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W</a:t>
            </a:r>
          </a:p>
        </c:rich>
      </c:tx>
      <c:layout>
        <c:manualLayout>
          <c:xMode val="edge"/>
          <c:yMode val="edge"/>
          <c:x val="3.1083333333333327E-2"/>
          <c:y val="2.777777777777777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view3D>
      <c:rotX val="15"/>
      <c:rotY val="20"/>
      <c:depthPercent val="100"/>
      <c:rAngAx val="1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>
        <c:manualLayout>
          <c:layoutTarget val="inner"/>
          <c:xMode val="edge"/>
          <c:yMode val="edge"/>
          <c:x val="5.5576334208223971E-2"/>
          <c:y val="0.12083333333333335"/>
          <c:w val="0.85275699912510938"/>
          <c:h val="0.68373323126275887"/>
        </c:manualLayout>
      </c:layout>
      <c:bar3DChart>
        <c:barDir val="col"/>
        <c:grouping val="clustered"/>
        <c:varyColors val="0"/>
        <c:ser>
          <c:idx val="0"/>
          <c:order val="0"/>
          <c:tx>
            <c:strRef>
              <c:f>Sheet3!$Y$49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  <a:sp3d/>
          </c:spPr>
          <c:invertIfNegative val="0"/>
          <c:cat>
            <c:strRef>
              <c:f>Sheet3!$Z$48:$AG$48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3!$Z$49:$AG$49</c:f>
              <c:numCache>
                <c:formatCode>General</c:formatCode>
                <c:ptCount val="8"/>
                <c:pt idx="0">
                  <c:v>6.76</c:v>
                </c:pt>
                <c:pt idx="1">
                  <c:v>6.6660000000000004</c:v>
                </c:pt>
                <c:pt idx="2">
                  <c:v>5.7839999999999998</c:v>
                </c:pt>
                <c:pt idx="3">
                  <c:v>5.9619999999999997</c:v>
                </c:pt>
                <c:pt idx="4">
                  <c:v>8.6820000000000004</c:v>
                </c:pt>
                <c:pt idx="5">
                  <c:v>7.7549999999999999</c:v>
                </c:pt>
                <c:pt idx="6">
                  <c:v>4.3609999999999998</c:v>
                </c:pt>
                <c:pt idx="7">
                  <c:v>4.578999999999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B9E-43BB-9ADB-1E0304B2F237}"/>
            </c:ext>
          </c:extLst>
        </c:ser>
        <c:ser>
          <c:idx val="1"/>
          <c:order val="1"/>
          <c:tx>
            <c:strRef>
              <c:f>Sheet3!$Y$50</c:f>
              <c:strCache>
                <c:ptCount val="1"/>
                <c:pt idx="0">
                  <c:v>D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  <a:sp3d/>
          </c:spPr>
          <c:invertIfNegative val="0"/>
          <c:cat>
            <c:strRef>
              <c:f>Sheet3!$Z$48:$AG$48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3!$Z$50:$AG$50</c:f>
              <c:numCache>
                <c:formatCode>General</c:formatCode>
                <c:ptCount val="8"/>
                <c:pt idx="0">
                  <c:v>3.51</c:v>
                </c:pt>
                <c:pt idx="1">
                  <c:v>4.4420000000000002</c:v>
                </c:pt>
                <c:pt idx="2">
                  <c:v>3.536</c:v>
                </c:pt>
                <c:pt idx="3">
                  <c:v>2.1850000000000001</c:v>
                </c:pt>
                <c:pt idx="4">
                  <c:v>5.5019999999999998</c:v>
                </c:pt>
                <c:pt idx="5">
                  <c:v>4.4180000000000001</c:v>
                </c:pt>
                <c:pt idx="6">
                  <c:v>5.19</c:v>
                </c:pt>
                <c:pt idx="7">
                  <c:v>6.168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B9E-43BB-9ADB-1E0304B2F237}"/>
            </c:ext>
          </c:extLst>
        </c:ser>
        <c:ser>
          <c:idx val="2"/>
          <c:order val="2"/>
          <c:tx>
            <c:strRef>
              <c:f>Sheet3!$Y$51</c:f>
              <c:strCache>
                <c:ptCount val="1"/>
                <c:pt idx="0">
                  <c:v>NSA</c:v>
                </c:pt>
              </c:strCache>
            </c:strRef>
          </c:tx>
          <c:spPr>
            <a:solidFill>
              <a:srgbClr val="002060"/>
            </a:solidFill>
            <a:ln>
              <a:noFill/>
            </a:ln>
            <a:effectLst/>
            <a:sp3d/>
          </c:spPr>
          <c:invertIfNegative val="0"/>
          <c:cat>
            <c:strRef>
              <c:f>Sheet3!$Z$48:$AG$48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3!$Z$51:$AG$51</c:f>
              <c:numCache>
                <c:formatCode>General</c:formatCode>
                <c:ptCount val="8"/>
                <c:pt idx="0">
                  <c:v>6.7370000000000001</c:v>
                </c:pt>
                <c:pt idx="1">
                  <c:v>3.964</c:v>
                </c:pt>
                <c:pt idx="2">
                  <c:v>6.0629999999999997</c:v>
                </c:pt>
                <c:pt idx="3">
                  <c:v>6.9569999999999999</c:v>
                </c:pt>
                <c:pt idx="4">
                  <c:v>6.2930000000000001</c:v>
                </c:pt>
                <c:pt idx="5">
                  <c:v>5.3710000000000004</c:v>
                </c:pt>
                <c:pt idx="6">
                  <c:v>5.1520000000000001</c:v>
                </c:pt>
                <c:pt idx="7">
                  <c:v>5.70600000000000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B9E-43BB-9ADB-1E0304B2F237}"/>
            </c:ext>
          </c:extLst>
        </c:ser>
        <c:ser>
          <c:idx val="3"/>
          <c:order val="3"/>
          <c:tx>
            <c:strRef>
              <c:f>Sheet3!$Y$52</c:f>
              <c:strCache>
                <c:ptCount val="1"/>
                <c:pt idx="0">
                  <c:v>DSA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  <a:sp3d/>
          </c:spPr>
          <c:invertIfNegative val="0"/>
          <c:cat>
            <c:strRef>
              <c:f>Sheet3!$Z$48:$AG$48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3!$Z$52:$AG$52</c:f>
              <c:numCache>
                <c:formatCode>General</c:formatCode>
                <c:ptCount val="8"/>
                <c:pt idx="0">
                  <c:v>4.2140000000000004</c:v>
                </c:pt>
                <c:pt idx="1">
                  <c:v>4.3920000000000003</c:v>
                </c:pt>
                <c:pt idx="2">
                  <c:v>3.7349999999999999</c:v>
                </c:pt>
                <c:pt idx="3">
                  <c:v>5.952</c:v>
                </c:pt>
                <c:pt idx="4">
                  <c:v>3.141</c:v>
                </c:pt>
                <c:pt idx="5">
                  <c:v>3.7120000000000002</c:v>
                </c:pt>
                <c:pt idx="6">
                  <c:v>5.2990000000000004</c:v>
                </c:pt>
                <c:pt idx="7">
                  <c:v>6.22200000000000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1B9E-43BB-9ADB-1E0304B2F23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592902512"/>
        <c:axId val="592906472"/>
        <c:axId val="0"/>
      </c:bar3DChart>
      <c:catAx>
        <c:axId val="5929025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5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92906472"/>
        <c:crosses val="autoZero"/>
        <c:auto val="1"/>
        <c:lblAlgn val="ctr"/>
        <c:lblOffset val="100"/>
        <c:noMultiLvlLbl val="0"/>
      </c:catAx>
      <c:valAx>
        <c:axId val="59290647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9290251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0297090988626434"/>
          <c:y val="0.1024752114319043"/>
          <c:w val="0.28294685039370077"/>
          <c:h val="7.345071449402157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b="1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A</a:t>
            </a:r>
          </a:p>
        </c:rich>
      </c:tx>
      <c:layout>
        <c:manualLayout>
          <c:xMode val="edge"/>
          <c:yMode val="edge"/>
          <c:x val="3.6874890638670166E-2"/>
          <c:y val="2.314814814814814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view3D>
      <c:rotX val="15"/>
      <c:rotY val="20"/>
      <c:depthPercent val="100"/>
      <c:rAngAx val="1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>
        <c:manualLayout>
          <c:layoutTarget val="inner"/>
          <c:xMode val="edge"/>
          <c:yMode val="edge"/>
          <c:x val="7.6291182135154068E-2"/>
          <c:y val="0.10694444444444444"/>
          <c:w val="0.8931532322023763"/>
          <c:h val="0.67888100461202117"/>
        </c:manualLayout>
      </c:layout>
      <c:bar3DChart>
        <c:barDir val="col"/>
        <c:grouping val="clustered"/>
        <c:varyColors val="0"/>
        <c:ser>
          <c:idx val="0"/>
          <c:order val="0"/>
          <c:tx>
            <c:strRef>
              <c:f>Sheet3!$Y$54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  <a:sp3d/>
          </c:spPr>
          <c:invertIfNegative val="0"/>
          <c:cat>
            <c:strRef>
              <c:f>Sheet3!$Z$53:$AG$53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3!$Z$54:$AG$54</c:f>
              <c:numCache>
                <c:formatCode>General</c:formatCode>
                <c:ptCount val="8"/>
                <c:pt idx="0">
                  <c:v>26.106000000000002</c:v>
                </c:pt>
                <c:pt idx="1">
                  <c:v>32.445</c:v>
                </c:pt>
                <c:pt idx="2">
                  <c:v>22.457999999999998</c:v>
                </c:pt>
                <c:pt idx="3">
                  <c:v>11.45</c:v>
                </c:pt>
                <c:pt idx="4">
                  <c:v>13.773999999999999</c:v>
                </c:pt>
                <c:pt idx="5">
                  <c:v>18.108000000000001</c:v>
                </c:pt>
                <c:pt idx="6">
                  <c:v>25.212</c:v>
                </c:pt>
                <c:pt idx="7">
                  <c:v>21.466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97C-4283-9710-508A0C8E0CFA}"/>
            </c:ext>
          </c:extLst>
        </c:ser>
        <c:ser>
          <c:idx val="1"/>
          <c:order val="1"/>
          <c:tx>
            <c:strRef>
              <c:f>Sheet3!$Y$55</c:f>
              <c:strCache>
                <c:ptCount val="1"/>
                <c:pt idx="0">
                  <c:v>D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  <a:sp3d/>
          </c:spPr>
          <c:invertIfNegative val="0"/>
          <c:cat>
            <c:strRef>
              <c:f>Sheet3!$Z$53:$AG$53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3!$Z$55:$AG$55</c:f>
              <c:numCache>
                <c:formatCode>General</c:formatCode>
                <c:ptCount val="8"/>
                <c:pt idx="0">
                  <c:v>19.745999999999999</c:v>
                </c:pt>
                <c:pt idx="1">
                  <c:v>17.431999999999999</c:v>
                </c:pt>
                <c:pt idx="2">
                  <c:v>14.606999999999999</c:v>
                </c:pt>
                <c:pt idx="3">
                  <c:v>12.353</c:v>
                </c:pt>
                <c:pt idx="4">
                  <c:v>17.323</c:v>
                </c:pt>
                <c:pt idx="5">
                  <c:v>17.751000000000001</c:v>
                </c:pt>
                <c:pt idx="6">
                  <c:v>19.113</c:v>
                </c:pt>
                <c:pt idx="7">
                  <c:v>18.088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97C-4283-9710-508A0C8E0CFA}"/>
            </c:ext>
          </c:extLst>
        </c:ser>
        <c:ser>
          <c:idx val="2"/>
          <c:order val="2"/>
          <c:tx>
            <c:strRef>
              <c:f>Sheet3!$Y$56</c:f>
              <c:strCache>
                <c:ptCount val="1"/>
                <c:pt idx="0">
                  <c:v>NSA</c:v>
                </c:pt>
              </c:strCache>
            </c:strRef>
          </c:tx>
          <c:spPr>
            <a:solidFill>
              <a:srgbClr val="002060"/>
            </a:solidFill>
            <a:ln>
              <a:noFill/>
            </a:ln>
            <a:effectLst/>
            <a:sp3d/>
          </c:spPr>
          <c:invertIfNegative val="0"/>
          <c:cat>
            <c:strRef>
              <c:f>Sheet3!$Z$53:$AG$53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3!$Z$56:$AG$56</c:f>
              <c:numCache>
                <c:formatCode>General</c:formatCode>
                <c:ptCount val="8"/>
                <c:pt idx="0">
                  <c:v>30.213000000000001</c:v>
                </c:pt>
                <c:pt idx="1">
                  <c:v>36.896999999999998</c:v>
                </c:pt>
                <c:pt idx="2">
                  <c:v>15.288</c:v>
                </c:pt>
                <c:pt idx="3">
                  <c:v>20.399999999999999</c:v>
                </c:pt>
                <c:pt idx="4">
                  <c:v>19.548999999999999</c:v>
                </c:pt>
                <c:pt idx="5">
                  <c:v>15.766</c:v>
                </c:pt>
                <c:pt idx="6">
                  <c:v>16.925999999999998</c:v>
                </c:pt>
                <c:pt idx="7">
                  <c:v>20.6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97C-4283-9710-508A0C8E0CFA}"/>
            </c:ext>
          </c:extLst>
        </c:ser>
        <c:ser>
          <c:idx val="3"/>
          <c:order val="3"/>
          <c:tx>
            <c:strRef>
              <c:f>Sheet3!$Y$57</c:f>
              <c:strCache>
                <c:ptCount val="1"/>
                <c:pt idx="0">
                  <c:v>DSA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  <a:sp3d/>
          </c:spPr>
          <c:invertIfNegative val="0"/>
          <c:cat>
            <c:strRef>
              <c:f>Sheet3!$Z$53:$AG$53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3!$Z$57:$AG$57</c:f>
              <c:numCache>
                <c:formatCode>General</c:formatCode>
                <c:ptCount val="8"/>
                <c:pt idx="0">
                  <c:v>23.125</c:v>
                </c:pt>
                <c:pt idx="1">
                  <c:v>24.427</c:v>
                </c:pt>
                <c:pt idx="2">
                  <c:v>15.028</c:v>
                </c:pt>
                <c:pt idx="3">
                  <c:v>19.007999999999999</c:v>
                </c:pt>
                <c:pt idx="4">
                  <c:v>5.4249999999999998</c:v>
                </c:pt>
                <c:pt idx="5">
                  <c:v>13.909000000000001</c:v>
                </c:pt>
                <c:pt idx="6">
                  <c:v>12.897</c:v>
                </c:pt>
                <c:pt idx="7">
                  <c:v>13.0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697C-4283-9710-508A0C8E0CF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592918712"/>
        <c:axId val="592911152"/>
        <c:axId val="0"/>
      </c:bar3DChart>
      <c:catAx>
        <c:axId val="5929187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5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92911152"/>
        <c:crosses val="autoZero"/>
        <c:auto val="1"/>
        <c:lblAlgn val="ctr"/>
        <c:lblOffset val="100"/>
        <c:noMultiLvlLbl val="0"/>
      </c:catAx>
      <c:valAx>
        <c:axId val="59291115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9291871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59185979877515316"/>
          <c:y val="0.14877150772820061"/>
          <c:w val="0.28294685039370077"/>
          <c:h val="7.345071449402157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b="1" dirty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. L</a:t>
            </a:r>
          </a:p>
        </c:rich>
      </c:tx>
      <c:layout>
        <c:manualLayout>
          <c:xMode val="edge"/>
          <c:yMode val="edge"/>
          <c:x val="3.3027777777777781E-2"/>
          <c:y val="2.314814814814814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view3D>
      <c:rotX val="15"/>
      <c:rotY val="20"/>
      <c:depthPercent val="100"/>
      <c:rAngAx val="1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>
        <c:manualLayout>
          <c:layoutTarget val="inner"/>
          <c:xMode val="edge"/>
          <c:yMode val="edge"/>
          <c:x val="8.8260643985321852E-2"/>
          <c:y val="0.11620370370370373"/>
          <c:w val="0.88118377035220863"/>
          <c:h val="0.6577358711292568"/>
        </c:manualLayout>
      </c:layout>
      <c:bar3DChart>
        <c:barDir val="col"/>
        <c:grouping val="clustered"/>
        <c:varyColors val="0"/>
        <c:ser>
          <c:idx val="0"/>
          <c:order val="0"/>
          <c:tx>
            <c:strRef>
              <c:f>Sheet3!$Y$59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  <a:sp3d/>
          </c:spPr>
          <c:invertIfNegative val="0"/>
          <c:cat>
            <c:strRef>
              <c:f>Sheet3!$Z$58:$AG$58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3!$Z$59:$AG$59</c:f>
              <c:numCache>
                <c:formatCode>0.00</c:formatCode>
                <c:ptCount val="8"/>
                <c:pt idx="0">
                  <c:v>15</c:v>
                </c:pt>
                <c:pt idx="1">
                  <c:v>13</c:v>
                </c:pt>
                <c:pt idx="2">
                  <c:v>14</c:v>
                </c:pt>
                <c:pt idx="3">
                  <c:v>10</c:v>
                </c:pt>
                <c:pt idx="4">
                  <c:v>13</c:v>
                </c:pt>
                <c:pt idx="5">
                  <c:v>12</c:v>
                </c:pt>
                <c:pt idx="6">
                  <c:v>14</c:v>
                </c:pt>
                <c:pt idx="7">
                  <c:v>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935-404E-A8CF-90D0D02B3C19}"/>
            </c:ext>
          </c:extLst>
        </c:ser>
        <c:ser>
          <c:idx val="1"/>
          <c:order val="1"/>
          <c:tx>
            <c:strRef>
              <c:f>Sheet3!$Y$60</c:f>
              <c:strCache>
                <c:ptCount val="1"/>
                <c:pt idx="0">
                  <c:v>D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  <a:sp3d/>
          </c:spPr>
          <c:invertIfNegative val="0"/>
          <c:cat>
            <c:strRef>
              <c:f>Sheet3!$Z$58:$AG$58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3!$Z$60:$AG$60</c:f>
              <c:numCache>
                <c:formatCode>0.00</c:formatCode>
                <c:ptCount val="8"/>
                <c:pt idx="0">
                  <c:v>13</c:v>
                </c:pt>
                <c:pt idx="1">
                  <c:v>12</c:v>
                </c:pt>
                <c:pt idx="2">
                  <c:v>12</c:v>
                </c:pt>
                <c:pt idx="3">
                  <c:v>6</c:v>
                </c:pt>
                <c:pt idx="4">
                  <c:v>11</c:v>
                </c:pt>
                <c:pt idx="5">
                  <c:v>12</c:v>
                </c:pt>
                <c:pt idx="6">
                  <c:v>8</c:v>
                </c:pt>
                <c:pt idx="7">
                  <c:v>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935-404E-A8CF-90D0D02B3C19}"/>
            </c:ext>
          </c:extLst>
        </c:ser>
        <c:ser>
          <c:idx val="2"/>
          <c:order val="2"/>
          <c:tx>
            <c:strRef>
              <c:f>Sheet3!$Y$61</c:f>
              <c:strCache>
                <c:ptCount val="1"/>
                <c:pt idx="0">
                  <c:v>NSA</c:v>
                </c:pt>
              </c:strCache>
            </c:strRef>
          </c:tx>
          <c:spPr>
            <a:solidFill>
              <a:srgbClr val="002060"/>
            </a:solidFill>
            <a:ln>
              <a:noFill/>
            </a:ln>
            <a:effectLst/>
            <a:sp3d/>
          </c:spPr>
          <c:invertIfNegative val="0"/>
          <c:cat>
            <c:strRef>
              <c:f>Sheet3!$Z$58:$AG$58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3!$Z$61:$AG$61</c:f>
              <c:numCache>
                <c:formatCode>0.00</c:formatCode>
                <c:ptCount val="8"/>
                <c:pt idx="0">
                  <c:v>13</c:v>
                </c:pt>
                <c:pt idx="1">
                  <c:v>11</c:v>
                </c:pt>
                <c:pt idx="2">
                  <c:v>13</c:v>
                </c:pt>
                <c:pt idx="3">
                  <c:v>8</c:v>
                </c:pt>
                <c:pt idx="4">
                  <c:v>9</c:v>
                </c:pt>
                <c:pt idx="5">
                  <c:v>13</c:v>
                </c:pt>
                <c:pt idx="6">
                  <c:v>17</c:v>
                </c:pt>
                <c:pt idx="7">
                  <c:v>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935-404E-A8CF-90D0D02B3C19}"/>
            </c:ext>
          </c:extLst>
        </c:ser>
        <c:ser>
          <c:idx val="3"/>
          <c:order val="3"/>
          <c:tx>
            <c:strRef>
              <c:f>Sheet3!$Y$62</c:f>
              <c:strCache>
                <c:ptCount val="1"/>
                <c:pt idx="0">
                  <c:v>DSA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  <a:sp3d/>
          </c:spPr>
          <c:invertIfNegative val="0"/>
          <c:cat>
            <c:strRef>
              <c:f>Sheet3!$Z$58:$AG$58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3!$Z$62:$AG$62</c:f>
              <c:numCache>
                <c:formatCode>0.00</c:formatCode>
                <c:ptCount val="8"/>
                <c:pt idx="0">
                  <c:v>10</c:v>
                </c:pt>
                <c:pt idx="1">
                  <c:v>9</c:v>
                </c:pt>
                <c:pt idx="2">
                  <c:v>14</c:v>
                </c:pt>
                <c:pt idx="3">
                  <c:v>6</c:v>
                </c:pt>
                <c:pt idx="4">
                  <c:v>13</c:v>
                </c:pt>
                <c:pt idx="5">
                  <c:v>14</c:v>
                </c:pt>
                <c:pt idx="6">
                  <c:v>11</c:v>
                </c:pt>
                <c:pt idx="7">
                  <c:v>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9935-404E-A8CF-90D0D02B3C1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592944272"/>
        <c:axId val="592940312"/>
        <c:axId val="0"/>
      </c:bar3DChart>
      <c:catAx>
        <c:axId val="5929442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5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92940312"/>
        <c:crosses val="autoZero"/>
        <c:auto val="1"/>
        <c:lblAlgn val="ctr"/>
        <c:lblOffset val="100"/>
        <c:noMultiLvlLbl val="0"/>
      </c:catAx>
      <c:valAx>
        <c:axId val="592940312"/>
        <c:scaling>
          <c:orientation val="minMax"/>
        </c:scaling>
        <c:delete val="0"/>
        <c:axPos val="l"/>
        <c:numFmt formatCode="0" sourceLinked="0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9294427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52007020997375331"/>
          <c:y val="8.3911490230387839E-2"/>
          <c:w val="0.28294685039370077"/>
          <c:h val="7.345071449402157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b="1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. R</a:t>
            </a:r>
          </a:p>
        </c:rich>
      </c:tx>
      <c:layout>
        <c:manualLayout>
          <c:xMode val="edge"/>
          <c:yMode val="edge"/>
          <c:x val="1.6361111111111111E-2"/>
          <c:y val="2.314814814814814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view3D>
      <c:rotX val="15"/>
      <c:rotY val="20"/>
      <c:depthPercent val="100"/>
      <c:rAngAx val="1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>
        <c:manualLayout>
          <c:layoutTarget val="inner"/>
          <c:xMode val="edge"/>
          <c:yMode val="edge"/>
          <c:x val="7.9283547597696014E-2"/>
          <c:y val="0.11157407407407409"/>
          <c:w val="0.84849418043822367"/>
          <c:h val="0.63859430750693136"/>
        </c:manualLayout>
      </c:layout>
      <c:bar3DChart>
        <c:barDir val="col"/>
        <c:grouping val="clustered"/>
        <c:varyColors val="0"/>
        <c:ser>
          <c:idx val="0"/>
          <c:order val="0"/>
          <c:tx>
            <c:strRef>
              <c:f>Sheet3!$Y$64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  <a:sp3d/>
          </c:spPr>
          <c:invertIfNegative val="0"/>
          <c:cat>
            <c:strRef>
              <c:f>Sheet3!$Z$63:$AG$63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3!$Z$64:$AG$64</c:f>
              <c:numCache>
                <c:formatCode>0.00</c:formatCode>
                <c:ptCount val="8"/>
                <c:pt idx="0">
                  <c:v>7</c:v>
                </c:pt>
                <c:pt idx="1">
                  <c:v>7</c:v>
                </c:pt>
                <c:pt idx="2">
                  <c:v>10</c:v>
                </c:pt>
                <c:pt idx="3">
                  <c:v>6</c:v>
                </c:pt>
                <c:pt idx="4">
                  <c:v>10</c:v>
                </c:pt>
                <c:pt idx="5">
                  <c:v>8</c:v>
                </c:pt>
                <c:pt idx="6">
                  <c:v>8</c:v>
                </c:pt>
                <c:pt idx="7">
                  <c:v>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69F-4D53-A0AD-DDD4C7A114B4}"/>
            </c:ext>
          </c:extLst>
        </c:ser>
        <c:ser>
          <c:idx val="1"/>
          <c:order val="1"/>
          <c:tx>
            <c:strRef>
              <c:f>Sheet3!$Y$65</c:f>
              <c:strCache>
                <c:ptCount val="1"/>
                <c:pt idx="0">
                  <c:v>D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  <a:sp3d/>
          </c:spPr>
          <c:invertIfNegative val="0"/>
          <c:cat>
            <c:strRef>
              <c:f>Sheet3!$Z$63:$AG$63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3!$Z$65:$AG$65</c:f>
              <c:numCache>
                <c:formatCode>0.00</c:formatCode>
                <c:ptCount val="8"/>
                <c:pt idx="0">
                  <c:v>5</c:v>
                </c:pt>
                <c:pt idx="1">
                  <c:v>6</c:v>
                </c:pt>
                <c:pt idx="2">
                  <c:v>5</c:v>
                </c:pt>
                <c:pt idx="3">
                  <c:v>4</c:v>
                </c:pt>
                <c:pt idx="4">
                  <c:v>7</c:v>
                </c:pt>
                <c:pt idx="5">
                  <c:v>4</c:v>
                </c:pt>
                <c:pt idx="6">
                  <c:v>6</c:v>
                </c:pt>
                <c:pt idx="7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69F-4D53-A0AD-DDD4C7A114B4}"/>
            </c:ext>
          </c:extLst>
        </c:ser>
        <c:ser>
          <c:idx val="2"/>
          <c:order val="2"/>
          <c:tx>
            <c:strRef>
              <c:f>Sheet3!$Y$66</c:f>
              <c:strCache>
                <c:ptCount val="1"/>
                <c:pt idx="0">
                  <c:v>NSA</c:v>
                </c:pt>
              </c:strCache>
            </c:strRef>
          </c:tx>
          <c:spPr>
            <a:solidFill>
              <a:srgbClr val="002060"/>
            </a:solidFill>
            <a:ln>
              <a:noFill/>
            </a:ln>
            <a:effectLst/>
            <a:sp3d/>
          </c:spPr>
          <c:invertIfNegative val="0"/>
          <c:cat>
            <c:strRef>
              <c:f>Sheet3!$Z$63:$AG$63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3!$Z$66:$AG$66</c:f>
              <c:numCache>
                <c:formatCode>0.00</c:formatCode>
                <c:ptCount val="8"/>
                <c:pt idx="0">
                  <c:v>6</c:v>
                </c:pt>
                <c:pt idx="1">
                  <c:v>7</c:v>
                </c:pt>
                <c:pt idx="2">
                  <c:v>9</c:v>
                </c:pt>
                <c:pt idx="3">
                  <c:v>7</c:v>
                </c:pt>
                <c:pt idx="4">
                  <c:v>6</c:v>
                </c:pt>
                <c:pt idx="5">
                  <c:v>7</c:v>
                </c:pt>
                <c:pt idx="6">
                  <c:v>6</c:v>
                </c:pt>
                <c:pt idx="7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69F-4D53-A0AD-DDD4C7A114B4}"/>
            </c:ext>
          </c:extLst>
        </c:ser>
        <c:ser>
          <c:idx val="3"/>
          <c:order val="3"/>
          <c:tx>
            <c:strRef>
              <c:f>Sheet3!$Y$67</c:f>
              <c:strCache>
                <c:ptCount val="1"/>
                <c:pt idx="0">
                  <c:v>DSA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  <a:sp3d/>
          </c:spPr>
          <c:invertIfNegative val="0"/>
          <c:cat>
            <c:strRef>
              <c:f>Sheet3!$Z$63:$AG$63</c:f>
              <c:strCache>
                <c:ptCount val="8"/>
                <c:pt idx="0">
                  <c:v>WAS_007</c:v>
                </c:pt>
                <c:pt idx="1">
                  <c:v>WAS_024</c:v>
                </c:pt>
                <c:pt idx="2">
                  <c:v>WAS_031</c:v>
                </c:pt>
                <c:pt idx="3">
                  <c:v>IPK_040</c:v>
                </c:pt>
                <c:pt idx="4">
                  <c:v>IPK_046</c:v>
                </c:pt>
                <c:pt idx="5">
                  <c:v>IPK_050</c:v>
                </c:pt>
                <c:pt idx="6">
                  <c:v>IPK_071</c:v>
                </c:pt>
                <c:pt idx="7">
                  <c:v>IPK_105</c:v>
                </c:pt>
              </c:strCache>
            </c:strRef>
          </c:cat>
          <c:val>
            <c:numRef>
              <c:f>Sheet3!$Z$67:$AG$67</c:f>
              <c:numCache>
                <c:formatCode>0.00</c:formatCode>
                <c:ptCount val="8"/>
                <c:pt idx="0">
                  <c:v>5</c:v>
                </c:pt>
                <c:pt idx="1">
                  <c:v>6</c:v>
                </c:pt>
                <c:pt idx="2">
                  <c:v>5</c:v>
                </c:pt>
                <c:pt idx="3">
                  <c:v>5</c:v>
                </c:pt>
                <c:pt idx="4">
                  <c:v>5</c:v>
                </c:pt>
                <c:pt idx="5">
                  <c:v>6</c:v>
                </c:pt>
                <c:pt idx="6">
                  <c:v>4</c:v>
                </c:pt>
                <c:pt idx="7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969F-4D53-A0AD-DDD4C7A114B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731232600"/>
        <c:axId val="726104584"/>
        <c:axId val="0"/>
      </c:bar3DChart>
      <c:catAx>
        <c:axId val="7312326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5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726104584"/>
        <c:crosses val="autoZero"/>
        <c:auto val="1"/>
        <c:lblAlgn val="ctr"/>
        <c:lblOffset val="100"/>
        <c:noMultiLvlLbl val="0"/>
      </c:catAx>
      <c:valAx>
        <c:axId val="726104584"/>
        <c:scaling>
          <c:orientation val="minMax"/>
        </c:scaling>
        <c:delete val="0"/>
        <c:axPos val="l"/>
        <c:numFmt formatCode="0" sourceLinked="0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73123260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2562576552930882"/>
          <c:y val="8.8541119860017448E-2"/>
          <c:w val="0.28294685039370077"/>
          <c:h val="7.345071449402157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</cdr:x>
      <cdr:y>0.01704</cdr:y>
    </cdr:from>
    <cdr:to>
      <cdr:x>0.12459</cdr:x>
      <cdr:y>0.12407</cdr:y>
    </cdr:to>
    <cdr:sp macro="" textlink="">
      <cdr:nvSpPr>
        <cdr:cNvPr id="2" name="TextBox 18">
          <a:extLst xmlns:a="http://schemas.openxmlformats.org/drawingml/2006/main">
            <a:ext uri="{FF2B5EF4-FFF2-40B4-BE49-F238E27FC236}">
              <a16:creationId xmlns:a16="http://schemas.microsoft.com/office/drawing/2014/main" id="{31FCAC5F-41E5-A58B-B4DD-22728B937426}"/>
            </a:ext>
          </a:extLst>
        </cdr:cNvPr>
        <cdr:cNvSpPr txBox="1"/>
      </cdr:nvSpPr>
      <cdr:spPr>
        <a:xfrm xmlns:a="http://schemas.openxmlformats.org/drawingml/2006/main">
          <a:off x="0" y="49008"/>
          <a:ext cx="551190" cy="307777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1400" b="1" dirty="0">
              <a:latin typeface="Times New Roman" panose="02020603050405020304" pitchFamily="18" charset="0"/>
              <a:cs typeface="Times New Roman" panose="02020603050405020304" pitchFamily="18" charset="0"/>
            </a:rPr>
            <a:t>(b)</a:t>
          </a:r>
          <a:endParaRPr lang="en-US" sz="14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01904</cdr:x>
      <cdr:y>0</cdr:y>
    </cdr:from>
    <cdr:to>
      <cdr:x>0.13409</cdr:x>
      <cdr:y>0.0952</cdr:y>
    </cdr:to>
    <cdr:sp macro="" textlink="">
      <cdr:nvSpPr>
        <cdr:cNvPr id="2" name="TextBox 18">
          <a:extLst xmlns:a="http://schemas.openxmlformats.org/drawingml/2006/main">
            <a:ext uri="{FF2B5EF4-FFF2-40B4-BE49-F238E27FC236}">
              <a16:creationId xmlns:a16="http://schemas.microsoft.com/office/drawing/2014/main" id="{31FCAC5F-41E5-A58B-B4DD-22728B937426}"/>
            </a:ext>
          </a:extLst>
        </cdr:cNvPr>
        <cdr:cNvSpPr txBox="1"/>
      </cdr:nvSpPr>
      <cdr:spPr>
        <a:xfrm xmlns:a="http://schemas.openxmlformats.org/drawingml/2006/main">
          <a:off x="81387" y="0"/>
          <a:ext cx="491786" cy="307777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1400" b="1" dirty="0">
              <a:latin typeface="Times New Roman" panose="02020603050405020304" pitchFamily="18" charset="0"/>
              <a:cs typeface="Times New Roman" panose="02020603050405020304" pitchFamily="18" charset="0"/>
            </a:rPr>
            <a:t>(d)</a:t>
          </a:r>
          <a:endParaRPr lang="en-US" sz="14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</cdr:x>
      <cdr:y>0.00113</cdr:y>
    </cdr:from>
    <cdr:to>
      <cdr:x>0.09056</cdr:x>
      <cdr:y>0.09801</cdr:y>
    </cdr:to>
    <cdr:sp macro="" textlink="">
      <cdr:nvSpPr>
        <cdr:cNvPr id="2" name="TextBox 18">
          <a:extLst xmlns:a="http://schemas.openxmlformats.org/drawingml/2006/main">
            <a:ext uri="{FF2B5EF4-FFF2-40B4-BE49-F238E27FC236}">
              <a16:creationId xmlns:a16="http://schemas.microsoft.com/office/drawing/2014/main" id="{31FCAC5F-41E5-A58B-B4DD-22728B937426}"/>
            </a:ext>
          </a:extLst>
        </cdr:cNvPr>
        <cdr:cNvSpPr txBox="1"/>
      </cdr:nvSpPr>
      <cdr:spPr>
        <a:xfrm xmlns:a="http://schemas.openxmlformats.org/drawingml/2006/main">
          <a:off x="0" y="3583"/>
          <a:ext cx="414018" cy="307777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1400" b="1" dirty="0">
              <a:latin typeface="Times New Roman" panose="02020603050405020304" pitchFamily="18" charset="0"/>
              <a:cs typeface="Times New Roman" panose="02020603050405020304" pitchFamily="18" charset="0"/>
            </a:rPr>
            <a:t>(e)</a:t>
          </a:r>
          <a:endParaRPr lang="en-US" sz="14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09305</cdr:x>
      <cdr:y>0.09688</cdr:y>
    </cdr:to>
    <cdr:sp macro="" textlink="">
      <cdr:nvSpPr>
        <cdr:cNvPr id="2" name="TextBox 18">
          <a:extLst xmlns:a="http://schemas.openxmlformats.org/drawingml/2006/main">
            <a:ext uri="{FF2B5EF4-FFF2-40B4-BE49-F238E27FC236}">
              <a16:creationId xmlns:a16="http://schemas.microsoft.com/office/drawing/2014/main" id="{31FCAC5F-41E5-A58B-B4DD-22728B937426}"/>
            </a:ext>
          </a:extLst>
        </cdr:cNvPr>
        <cdr:cNvSpPr txBox="1"/>
      </cdr:nvSpPr>
      <cdr:spPr>
        <a:xfrm xmlns:a="http://schemas.openxmlformats.org/drawingml/2006/main">
          <a:off x="0" y="0"/>
          <a:ext cx="405564" cy="307777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1400" b="1" dirty="0">
              <a:latin typeface="Times New Roman" panose="02020603050405020304" pitchFamily="18" charset="0"/>
              <a:cs typeface="Times New Roman" panose="02020603050405020304" pitchFamily="18" charset="0"/>
            </a:rPr>
            <a:t>(f)</a:t>
          </a:r>
          <a:endParaRPr lang="en-US" sz="14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09483</cdr:x>
      <cdr:y>0.1122</cdr:y>
    </cdr:to>
    <cdr:sp macro="" textlink="">
      <cdr:nvSpPr>
        <cdr:cNvPr id="2" name="TextBox 18">
          <a:extLst xmlns:a="http://schemas.openxmlformats.org/drawingml/2006/main">
            <a:ext uri="{FF2B5EF4-FFF2-40B4-BE49-F238E27FC236}">
              <a16:creationId xmlns:a16="http://schemas.microsoft.com/office/drawing/2014/main" id="{31FCAC5F-41E5-A58B-B4DD-22728B937426}"/>
            </a:ext>
          </a:extLst>
        </cdr:cNvPr>
        <cdr:cNvSpPr txBox="1"/>
      </cdr:nvSpPr>
      <cdr:spPr>
        <a:xfrm xmlns:a="http://schemas.openxmlformats.org/drawingml/2006/main">
          <a:off x="0" y="-137530"/>
          <a:ext cx="433566" cy="307777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GB" sz="1400" b="1" dirty="0">
              <a:latin typeface="Times New Roman" panose="02020603050405020304" pitchFamily="18" charset="0"/>
              <a:cs typeface="Times New Roman" panose="02020603050405020304" pitchFamily="18" charset="0"/>
            </a:rPr>
            <a:t>(c)</a:t>
          </a:r>
          <a:endParaRPr lang="en-US" sz="14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FCB2E4-6DC0-FCE1-5842-AE99D03743B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EA78883-551C-D693-4225-400C0E06FF6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4BEAB4-0F0C-A113-3641-A47D5B70CD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EBA917-68DF-4514-BA2B-27F99C8D0ED7}" type="datetimeFigureOut">
              <a:rPr lang="en-GB" smtClean="0"/>
              <a:t>25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C05B21-BE8F-1779-78BD-E32B58B7A7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64FE7A-06D1-024B-EF19-BC37A58C36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EA8B7-98E9-44F2-9885-8C0C44675A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74352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A974CE-36B4-C423-C62C-8CCEDDA4F1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6E942AE-127C-44BD-C01B-0528B765B0D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3195FF-EEA4-98F7-E071-25A6DB67E9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EBA917-68DF-4514-BA2B-27F99C8D0ED7}" type="datetimeFigureOut">
              <a:rPr lang="en-GB" smtClean="0"/>
              <a:t>25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D5579E-9758-11FD-1EBB-3B16E3186E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0E0B05-E958-53FA-07DC-4D8379EBBF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EA8B7-98E9-44F2-9885-8C0C44675A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95239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133BEC4-B837-DD28-62D0-1101C8D56C8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9E675DD-C0F1-1F4F-A367-035E8185EE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A5707A-1265-D57A-8A07-7355D256E3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EBA917-68DF-4514-BA2B-27F99C8D0ED7}" type="datetimeFigureOut">
              <a:rPr lang="en-GB" smtClean="0"/>
              <a:t>25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33000F-BA58-7571-6856-1C32B60AB5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1F9903-1A99-E465-3186-08F1667DFC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EA8B7-98E9-44F2-9885-8C0C44675A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379548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C10293-712B-E5DE-6F2C-E69C9D42E27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960FA60-1415-E0B5-A8B2-7DA0D49AE08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8995BA-67A6-691C-D10B-BEF65B8F30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71C51F-398F-4573-B04D-5780E8D06E16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139D18-357D-322D-8D80-870FE48CC5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DEACD7-3F53-5F6D-4BE6-3D49B17781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F1B91-A9A0-4BD5-A217-C81EF2F013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5686783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FA66AB-8A1A-A2A7-B10D-4EDA89DD22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ADA9942-7232-3374-6334-F23E44491F0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715928-03F7-863A-5893-FDB63E0E68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71C51F-398F-4573-B04D-5780E8D06E16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63C8A4-64C0-FB64-2BCD-A16EAE3754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58DC22-8908-5E6B-BA94-ABB561686F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F1B91-A9A0-4BD5-A217-C81EF2F013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9879528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F2881A-A159-42A1-1B0A-25D4D94EF9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D5099B1-4BDF-22D3-B9D6-CB109F7A2D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AAB3ED-5C1C-2301-6D67-071F36DE3E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71C51F-398F-4573-B04D-5780E8D06E16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C76388-CDEE-447E-356E-BAF09FD6F8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7BCD48-4F01-C42C-78B0-B9C8D2CFDA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F1B91-A9A0-4BD5-A217-C81EF2F013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462088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1EA110-470F-AB9B-5D79-BFA49D419D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45A3EA0-D497-BD8A-FCF6-4489DA5756F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D7605C0-2495-CFC7-EDF7-7BF118655EB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A85DF9C-12D8-CF72-73BC-D085248C7C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71C51F-398F-4573-B04D-5780E8D06E16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C230339-0B10-D153-5B57-79DB80AC01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37E2393-805A-4165-7D1B-FF7D272644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F1B91-A9A0-4BD5-A217-C81EF2F013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7380558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E0F004-7A95-D3E8-5BF4-64CD000B7F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902A43-F65B-2227-2864-99F0C45A91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C5BE73C-FE6C-FEC3-A955-EBB23B1E382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20DADA3-6F37-D4AC-6B40-52D505EAB96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041FCA0-AF3E-B2DC-4AEF-F4C75726934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FD80CC8-ADB9-AE68-406B-99232E2502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71C51F-398F-4573-B04D-5780E8D06E16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08BF613-1208-547A-B10B-7086D16A8B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04496D2-8C07-6D74-09F9-32DE83ACC1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F1B91-A9A0-4BD5-A217-C81EF2F013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033697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9AB558-DE7B-0545-589C-A407F3D14F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D4BF54B-64A2-FA59-4392-17ECA00E02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71C51F-398F-4573-B04D-5780E8D06E16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5B7633A-369B-625D-BBC7-AD284D9A5B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D2CCB7B-EC7F-1340-C5FF-249C117873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F1B91-A9A0-4BD5-A217-C81EF2F013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3271156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E469EDB-902C-A972-1552-4F34002B43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71C51F-398F-4573-B04D-5780E8D06E16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A74CDD3-48AE-9746-E2F6-D438B0CA61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B6EBA90-D17B-1DEB-92F3-6D838149D4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F1B91-A9A0-4BD5-A217-C81EF2F013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449604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B2011D-DBCE-7DE3-6F10-9AB2763FD5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97441AA-6EB9-5E43-959D-4CA4F007C32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634D245-7B2D-7097-F587-C8C15C3B18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CE8BAFF-9583-B768-0F60-558F1BF286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71C51F-398F-4573-B04D-5780E8D06E16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6CA85B-DC38-4F4D-3461-33831B716F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80028ED-41A7-A90F-2C0E-C78E7299F5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F1B91-A9A0-4BD5-A217-C81EF2F013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39377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DD2425-731D-162F-43A5-3E64D10504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ED4575E-6887-6A63-BA73-1D44BD41270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2690AE-F242-AF8A-C7FD-AFFEE0127D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EBA917-68DF-4514-BA2B-27F99C8D0ED7}" type="datetimeFigureOut">
              <a:rPr lang="en-GB" smtClean="0"/>
              <a:t>25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0D354D-D484-9615-999B-6AE712C94E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F7234F-29CE-4610-1F39-5B98729FB0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EA8B7-98E9-44F2-9885-8C0C44675A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2619128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DF0249-AF0F-EFD1-D8C6-B5317A9EBF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D08FB7F-36BA-41E3-6DC8-FA4042641D2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59C8549-DF7F-4FBE-02FB-FA0C370585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8427A93-17B0-5795-FBF8-E93B7D250F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71C51F-398F-4573-B04D-5780E8D06E16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0363FD2-F43C-7098-CF70-07882D5883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DAAE74D-E748-D7C2-8C28-F453DD78C7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F1B91-A9A0-4BD5-A217-C81EF2F013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426072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D1AC4C-2AB6-4200-62B2-E145F6D8EE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8E5C45F-A815-E4D6-9F0C-878B5758CE7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E487F2-8CD7-09BB-7009-BD9BD0E606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71C51F-398F-4573-B04D-5780E8D06E16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AE9AE2-A5E6-2C7B-BF87-8E33A1E91E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F7DAA3-DD30-5C97-462E-E812ED6A00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F1B91-A9A0-4BD5-A217-C81EF2F013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4059879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547543A-6143-EB90-4C2C-9625F1C97BE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A5861EB-653A-1208-F814-1E8ED73CA06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ABB048-FC1C-68E7-DA2D-FD415BCA73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71C51F-398F-4573-B04D-5780E8D06E16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5D6D75-A773-61C1-50D4-E6E50D3E16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904FE8-07DC-D44D-4C4B-A2FF07B257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F1B91-A9A0-4BD5-A217-C81EF2F013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74379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F5DEE2-4FC3-5257-5983-3126016B83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7A63872-BC25-537A-AB7D-8AB31CC057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E4EE39-B8E6-60B9-315E-2FAE18C544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EBA917-68DF-4514-BA2B-27F99C8D0ED7}" type="datetimeFigureOut">
              <a:rPr lang="en-GB" smtClean="0"/>
              <a:t>25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AD3C26-3B4D-B37D-B3F4-F6AA89D756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05837B-03B3-2BC1-FFA7-21F588BB35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EA8B7-98E9-44F2-9885-8C0C44675A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85285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CB9E64-59DB-EEE4-C3CA-803BC5289B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8B0BA69-3A86-8532-58B0-2666FC8587B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8CF2A08-8640-4B2E-6F9E-6ADD4B88D7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E73E062-8D92-7455-F1BD-6777D3165C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EBA917-68DF-4514-BA2B-27F99C8D0ED7}" type="datetimeFigureOut">
              <a:rPr lang="en-GB" smtClean="0"/>
              <a:t>25/09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F7E8E4-26FA-5285-A948-2D06F0CD5F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CAEC0E3-87D1-E52D-5952-2FE59F15E8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EA8B7-98E9-44F2-9885-8C0C44675A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31424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DCD1B4-C3C5-6436-F81D-0D722FD573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63779A1-B1E0-4216-907B-7608F27A40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B973F32-6778-EA5C-0B9F-E8A90BE87D0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C274D3B-43D3-2C96-C320-915C45163F2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07CF721-6E6F-4F05-3A52-6D30B02B0FD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EB7A54F-A0B9-7E89-1144-86B5D169EF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EBA917-68DF-4514-BA2B-27F99C8D0ED7}" type="datetimeFigureOut">
              <a:rPr lang="en-GB" smtClean="0"/>
              <a:t>25/09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5F6E4E4-C542-A3C8-FA7B-2DAE03D766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EC0D6E4-D67E-FE37-E28F-42FF97E449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EA8B7-98E9-44F2-9885-8C0C44675A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95588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3A13F7-BA28-FB41-9024-60DB123B82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F245C74-809A-12A8-BDD8-DDE57B5FE9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EBA917-68DF-4514-BA2B-27F99C8D0ED7}" type="datetimeFigureOut">
              <a:rPr lang="en-GB" smtClean="0"/>
              <a:t>25/09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0B85F43-C0D4-8AB8-67AB-D078544D31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870B15E-8275-DDC7-FCAD-3CE86D40C2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EA8B7-98E9-44F2-9885-8C0C44675A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8780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2C3A953-05A0-4226-9B15-B0646144EB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EBA917-68DF-4514-BA2B-27F99C8D0ED7}" type="datetimeFigureOut">
              <a:rPr lang="en-GB" smtClean="0"/>
              <a:t>25/09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BD1781A-9BC4-FF33-903A-A99CCD8478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37A866E-B582-0B9C-1981-87009DC91F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EA8B7-98E9-44F2-9885-8C0C44675A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73877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F718DB-8807-6E78-2774-D83B37A238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ACE71B6-0A6E-9113-4558-039F8EEC77C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010FB28-26BD-7F28-8325-40D9A3F1880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5069600-1F9F-0FDA-0D61-BBDECA5D1E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EBA917-68DF-4514-BA2B-27F99C8D0ED7}" type="datetimeFigureOut">
              <a:rPr lang="en-GB" smtClean="0"/>
              <a:t>25/09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D1B27CC-7810-6968-5F28-25BBF07160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9A92E75-D89D-1800-1D2A-7D3DD7CFA7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EA8B7-98E9-44F2-9885-8C0C44675A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35672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62E71F-305C-ED5D-56C3-F78112C234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3D6B8F2-F596-33BA-A6FA-CD724D73C49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991F693-31EE-0EBB-1DFC-0AFCFD57AA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217738B-F1BB-BAAC-CD84-9A850D55E1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EBA917-68DF-4514-BA2B-27F99C8D0ED7}" type="datetimeFigureOut">
              <a:rPr lang="en-GB" smtClean="0"/>
              <a:t>25/09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86DFCD5-A63B-6197-B709-DCE0C48E94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D2A7929-FC72-420B-1BF4-0D82C51645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EA8B7-98E9-44F2-9885-8C0C44675A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67872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BD63F16-C860-CC79-6B47-894E2882D4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DC0E090-C0F4-A2E9-A1E8-20C922E537E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0535A2-226E-52A2-3C9C-9CF3151A664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8EBA917-68DF-4514-BA2B-27F99C8D0ED7}" type="datetimeFigureOut">
              <a:rPr lang="en-GB" smtClean="0"/>
              <a:t>25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3EC5E5-0209-5BC5-251A-2B10A709161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8C472F-71B3-9EA2-B3B0-BC00BB7C456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7CEA8B7-98E9-44F2-9885-8C0C44675A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17512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117395F-1232-0C13-ABE9-D274AFAE18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8743BA2-3D51-B654-1702-988DC7B14D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C0F49D-FE2B-1EFC-C2C6-2D09E440843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071C51F-398F-4573-B04D-5780E8D06E16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BCDBA33-A11F-7CA0-66D7-ABCDA726485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BFC439-692C-3BCF-8E78-1A868445A56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6CF1B91-A9A0-4BD5-A217-C81EF2F013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81321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8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1.xml"/><Relationship Id="rId7" Type="http://schemas.openxmlformats.org/officeDocument/2006/relationships/chart" Target="../charts/chart15.xml"/><Relationship Id="rId2" Type="http://schemas.openxmlformats.org/officeDocument/2006/relationships/chart" Target="../charts/chart10.xml"/><Relationship Id="rId1" Type="http://schemas.openxmlformats.org/officeDocument/2006/relationships/slideLayout" Target="../slideLayouts/slideLayout18.xml"/><Relationship Id="rId6" Type="http://schemas.openxmlformats.org/officeDocument/2006/relationships/chart" Target="../charts/chart14.xml"/><Relationship Id="rId5" Type="http://schemas.openxmlformats.org/officeDocument/2006/relationships/chart" Target="../charts/chart13.xml"/><Relationship Id="rId4" Type="http://schemas.openxmlformats.org/officeDocument/2006/relationships/chart" Target="../charts/char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C97D2135-B404-D768-4092-272913500C8B}"/>
              </a:ext>
            </a:extLst>
          </p:cNvPr>
          <p:cNvGrpSpPr/>
          <p:nvPr/>
        </p:nvGrpSpPr>
        <p:grpSpPr>
          <a:xfrm>
            <a:off x="148893" y="-1"/>
            <a:ext cx="12043107" cy="6061312"/>
            <a:chOff x="-190995" y="-113143"/>
            <a:chExt cx="12973457" cy="7780626"/>
          </a:xfrm>
        </p:grpSpPr>
        <p:graphicFrame>
          <p:nvGraphicFramePr>
            <p:cNvPr id="7" name="Chart 6">
              <a:extLst>
                <a:ext uri="{FF2B5EF4-FFF2-40B4-BE49-F238E27FC236}">
                  <a16:creationId xmlns:a16="http://schemas.microsoft.com/office/drawing/2014/main" id="{3A742FCA-23F8-74C1-587B-B8766380882F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695175057"/>
                </p:ext>
              </p:extLst>
            </p:nvPr>
          </p:nvGraphicFramePr>
          <p:xfrm>
            <a:off x="8020050" y="52303"/>
            <a:ext cx="443865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8" name="Chart 7">
              <a:extLst>
                <a:ext uri="{FF2B5EF4-FFF2-40B4-BE49-F238E27FC236}">
                  <a16:creationId xmlns:a16="http://schemas.microsoft.com/office/drawing/2014/main" id="{616015F9-B9EC-A2CB-E5A4-177C9989E937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86822812"/>
                </p:ext>
              </p:extLst>
            </p:nvPr>
          </p:nvGraphicFramePr>
          <p:xfrm>
            <a:off x="3853786" y="0"/>
            <a:ext cx="4438650" cy="268236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9" name="Chart 8">
              <a:extLst>
                <a:ext uri="{FF2B5EF4-FFF2-40B4-BE49-F238E27FC236}">
                  <a16:creationId xmlns:a16="http://schemas.microsoft.com/office/drawing/2014/main" id="{DDABDE02-9885-C41B-594A-6BBE8C65D817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30103630"/>
                </p:ext>
              </p:extLst>
            </p:nvPr>
          </p:nvGraphicFramePr>
          <p:xfrm>
            <a:off x="-190995" y="-113143"/>
            <a:ext cx="4572000" cy="279550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10" name="Chart 9">
              <a:extLst>
                <a:ext uri="{FF2B5EF4-FFF2-40B4-BE49-F238E27FC236}">
                  <a16:creationId xmlns:a16="http://schemas.microsoft.com/office/drawing/2014/main" id="{61B1CAB2-669D-4632-D5C8-C75FF9D5DFE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61344162"/>
                </p:ext>
              </p:extLst>
            </p:nvPr>
          </p:nvGraphicFramePr>
          <p:xfrm>
            <a:off x="-67490" y="2395883"/>
            <a:ext cx="4379397" cy="263690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11" name="Chart 10">
              <a:extLst>
                <a:ext uri="{FF2B5EF4-FFF2-40B4-BE49-F238E27FC236}">
                  <a16:creationId xmlns:a16="http://schemas.microsoft.com/office/drawing/2014/main" id="{C12390DE-51D4-CCED-AD92-B55C9D78795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44488890"/>
                </p:ext>
              </p:extLst>
            </p:nvPr>
          </p:nvGraphicFramePr>
          <p:xfrm>
            <a:off x="4057243" y="2350426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12" name="Chart 11">
              <a:extLst>
                <a:ext uri="{FF2B5EF4-FFF2-40B4-BE49-F238E27FC236}">
                  <a16:creationId xmlns:a16="http://schemas.microsoft.com/office/drawing/2014/main" id="{BDD78BCA-8504-71B4-C4A2-498DC30316D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74999503"/>
                </p:ext>
              </p:extLst>
            </p:nvPr>
          </p:nvGraphicFramePr>
          <p:xfrm>
            <a:off x="8210462" y="2304969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aphicFrame>
          <p:nvGraphicFramePr>
            <p:cNvPr id="13" name="Chart 12">
              <a:extLst>
                <a:ext uri="{FF2B5EF4-FFF2-40B4-BE49-F238E27FC236}">
                  <a16:creationId xmlns:a16="http://schemas.microsoft.com/office/drawing/2014/main" id="{30F654C8-A615-9E08-FB77-17C109128F8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5442927"/>
                </p:ext>
              </p:extLst>
            </p:nvPr>
          </p:nvGraphicFramePr>
          <p:xfrm>
            <a:off x="-126741" y="4924284"/>
            <a:ext cx="4572000" cy="274319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graphicFrame>
          <p:nvGraphicFramePr>
            <p:cNvPr id="14" name="Chart 13">
              <a:extLst>
                <a:ext uri="{FF2B5EF4-FFF2-40B4-BE49-F238E27FC236}">
                  <a16:creationId xmlns:a16="http://schemas.microsoft.com/office/drawing/2014/main" id="{16C79B1B-03FF-9103-14C0-9E72B0461AB4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848321398"/>
                </p:ext>
              </p:extLst>
            </p:nvPr>
          </p:nvGraphicFramePr>
          <p:xfrm>
            <a:off x="3984978" y="4903405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graphicFrame>
          <p:nvGraphicFramePr>
            <p:cNvPr id="15" name="Chart 14">
              <a:extLst>
                <a:ext uri="{FF2B5EF4-FFF2-40B4-BE49-F238E27FC236}">
                  <a16:creationId xmlns:a16="http://schemas.microsoft.com/office/drawing/2014/main" id="{97E8342D-96CB-4DBC-6F41-D127B34A7D2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33208408"/>
                </p:ext>
              </p:extLst>
            </p:nvPr>
          </p:nvGraphicFramePr>
          <p:xfrm>
            <a:off x="8181976" y="4874834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ECC4109C-D8B8-70D3-B6BD-6BD4CC0F2FA0}"/>
              </a:ext>
            </a:extLst>
          </p:cNvPr>
          <p:cNvSpPr txBox="1"/>
          <p:nvPr/>
        </p:nvSpPr>
        <p:spPr>
          <a:xfrm>
            <a:off x="304800" y="6061311"/>
            <a:ext cx="11586655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ementary Figure 1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: Grouped bar plot of 9 morphological and phenological </a:t>
            </a:r>
            <a:r>
              <a:rPr kumimoji="0" lang="en-GB" sz="14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raits of 45 DAS eight spring </a:t>
            </a:r>
            <a:r>
              <a:rPr kumimoji="0" lang="en-US" sz="14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T. </a:t>
            </a:r>
            <a:r>
              <a:rPr kumimoji="0" lang="en-US" sz="1400" b="0" i="1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aestivum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 </a:t>
            </a:r>
            <a:r>
              <a:rPr kumimoji="0" lang="en-GB" sz="14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nder different treatments (D, drought; DSA, drought with salicylic acid; NI, normal irrigation and NSA, normal irrigation with salicylic acid). Abbreviations: FW (fresh weight); DW (dry weight); </a:t>
            </a:r>
            <a:r>
              <a:rPr kumimoji="0" lang="en-GB" sz="1400" b="0" i="0" u="none" strike="noStrike" kern="1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hL</a:t>
            </a:r>
            <a:r>
              <a:rPr kumimoji="0" lang="en-GB" sz="14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shoot length); RW (root width); LA (leaf area); No. L (No. of leaves) and No. R (No. of roots).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8220603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20A4EB71-7DA5-E1FC-92C2-F9A9A42F69D9}"/>
              </a:ext>
            </a:extLst>
          </p:cNvPr>
          <p:cNvSpPr txBox="1"/>
          <p:nvPr/>
        </p:nvSpPr>
        <p:spPr>
          <a:xfrm>
            <a:off x="455141" y="5747553"/>
            <a:ext cx="11951563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ementary Figure 2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: Grouped bar plot of 5 physiological and biochemical </a:t>
            </a:r>
            <a:r>
              <a:rPr kumimoji="0" lang="en-GB" sz="14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raits of 45 DAS eight spring </a:t>
            </a:r>
            <a:r>
              <a:rPr kumimoji="0" lang="en-US" sz="14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T. aestivum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+mn-cs"/>
              </a:rPr>
              <a:t> </a:t>
            </a:r>
            <a:r>
              <a:rPr kumimoji="0" lang="en-GB" sz="14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nder different treatments (D, drought; DSA, drought with salicylic acid; NI, normal irrigation and NSA, normal irrigation with salicylic acid). Abbreviations: WC (water content); ML (membrane leakage); LG (leaf greenness); Carb (carbohydrates); </a:t>
            </a:r>
            <a:r>
              <a:rPr kumimoji="0" lang="en-GB" sz="1400" b="0" i="0" u="none" strike="noStrike" kern="1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oT</a:t>
            </a:r>
            <a:r>
              <a:rPr kumimoji="0" lang="en-GB" sz="14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protein) and </a:t>
            </a:r>
            <a:r>
              <a:rPr kumimoji="0" lang="en-GB" sz="1400" b="0" i="0" u="none" strike="noStrike" kern="1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oL</a:t>
            </a:r>
            <a:r>
              <a:rPr kumimoji="0" lang="en-GB" sz="1400" b="0" i="0" u="none" strike="noStrike" kern="1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proline</a:t>
            </a:r>
            <a:r>
              <a:rPr kumimoji="0" lang="en-GB" sz="14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ptos" panose="02110004020202020204"/>
              <a:ea typeface="+mn-ea"/>
              <a:cs typeface="+mn-cs"/>
            </a:endParaRPr>
          </a:p>
        </p:txBody>
      </p:sp>
      <p:graphicFrame>
        <p:nvGraphicFramePr>
          <p:cNvPr id="11" name="Chart 10">
            <a:extLst>
              <a:ext uri="{FF2B5EF4-FFF2-40B4-BE49-F238E27FC236}">
                <a16:creationId xmlns:a16="http://schemas.microsoft.com/office/drawing/2014/main" id="{B6744094-EE8A-7C2F-8400-3D2FB5BF3687}"/>
              </a:ext>
            </a:extLst>
          </p:cNvPr>
          <p:cNvGraphicFramePr>
            <a:graphicFrameLocks/>
          </p:cNvGraphicFramePr>
          <p:nvPr/>
        </p:nvGraphicFramePr>
        <p:xfrm>
          <a:off x="3872593" y="45682"/>
          <a:ext cx="4424039" cy="28757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3" name="Chart 12">
            <a:extLst>
              <a:ext uri="{FF2B5EF4-FFF2-40B4-BE49-F238E27FC236}">
                <a16:creationId xmlns:a16="http://schemas.microsoft.com/office/drawing/2014/main" id="{B11F4D27-0715-CEFF-C72F-9BFBE985108D}"/>
              </a:ext>
            </a:extLst>
          </p:cNvPr>
          <p:cNvGraphicFramePr>
            <a:graphicFrameLocks/>
          </p:cNvGraphicFramePr>
          <p:nvPr/>
        </p:nvGraphicFramePr>
        <p:xfrm>
          <a:off x="-89518" y="2586522"/>
          <a:ext cx="4274604" cy="32330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4" name="Chart 13">
            <a:extLst>
              <a:ext uri="{FF2B5EF4-FFF2-40B4-BE49-F238E27FC236}">
                <a16:creationId xmlns:a16="http://schemas.microsoft.com/office/drawing/2014/main" id="{C9B9C6BE-8A33-F711-6D8F-CB6A52F3E329}"/>
              </a:ext>
            </a:extLst>
          </p:cNvPr>
          <p:cNvGraphicFramePr>
            <a:graphicFrameLocks/>
          </p:cNvGraphicFramePr>
          <p:nvPr/>
        </p:nvGraphicFramePr>
        <p:xfrm>
          <a:off x="3872593" y="2666568"/>
          <a:ext cx="4572000" cy="31768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5" name="Chart 14">
            <a:extLst>
              <a:ext uri="{FF2B5EF4-FFF2-40B4-BE49-F238E27FC236}">
                <a16:creationId xmlns:a16="http://schemas.microsoft.com/office/drawing/2014/main" id="{45C2592D-C548-D317-41E5-1D6E93B0C43B}"/>
              </a:ext>
            </a:extLst>
          </p:cNvPr>
          <p:cNvGraphicFramePr>
            <a:graphicFrameLocks/>
          </p:cNvGraphicFramePr>
          <p:nvPr/>
        </p:nvGraphicFramePr>
        <p:xfrm>
          <a:off x="8047944" y="2666568"/>
          <a:ext cx="4358760" cy="31768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6" name="Chart 15">
            <a:extLst>
              <a:ext uri="{FF2B5EF4-FFF2-40B4-BE49-F238E27FC236}">
                <a16:creationId xmlns:a16="http://schemas.microsoft.com/office/drawing/2014/main" id="{8DB7B550-3381-DA05-B6C3-22AB0D892DCB}"/>
              </a:ext>
            </a:extLst>
          </p:cNvPr>
          <p:cNvGraphicFramePr>
            <a:graphicFrameLocks/>
          </p:cNvGraphicFramePr>
          <p:nvPr/>
        </p:nvGraphicFramePr>
        <p:xfrm>
          <a:off x="7834704" y="178186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pSp>
        <p:nvGrpSpPr>
          <p:cNvPr id="20" name="Group 19">
            <a:extLst>
              <a:ext uri="{FF2B5EF4-FFF2-40B4-BE49-F238E27FC236}">
                <a16:creationId xmlns:a16="http://schemas.microsoft.com/office/drawing/2014/main" id="{3FD33421-7F73-483B-6D24-9424B0DA7D04}"/>
              </a:ext>
            </a:extLst>
          </p:cNvPr>
          <p:cNvGrpSpPr/>
          <p:nvPr/>
        </p:nvGrpSpPr>
        <p:grpSpPr>
          <a:xfrm>
            <a:off x="-105955" y="3159"/>
            <a:ext cx="4463252" cy="2808883"/>
            <a:chOff x="-128915" y="49008"/>
            <a:chExt cx="4463252" cy="2808883"/>
          </a:xfrm>
        </p:grpSpPr>
        <p:graphicFrame>
          <p:nvGraphicFramePr>
            <p:cNvPr id="18" name="Chart 17">
              <a:extLst>
                <a:ext uri="{FF2B5EF4-FFF2-40B4-BE49-F238E27FC236}">
                  <a16:creationId xmlns:a16="http://schemas.microsoft.com/office/drawing/2014/main" id="{DC1D4585-1144-FE71-101D-FE5A8F818479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-128915" y="114691"/>
            <a:ext cx="4463252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31FCAC5F-41E5-A58B-B4DD-22728B937426}"/>
                </a:ext>
              </a:extLst>
            </p:cNvPr>
            <p:cNvSpPr txBox="1"/>
            <p:nvPr/>
          </p:nvSpPr>
          <p:spPr>
            <a:xfrm>
              <a:off x="0" y="49008"/>
              <a:ext cx="55119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rPr>
                <a:t>(a)</a:t>
              </a:r>
              <a:endPara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3524925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9</TotalTime>
  <Words>213</Words>
  <Application>Microsoft Office PowerPoint</Application>
  <PresentationFormat>Widescreen</PresentationFormat>
  <Paragraphs>2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ptos</vt:lpstr>
      <vt:lpstr>Aptos Display</vt:lpstr>
      <vt:lpstr>Arial</vt:lpstr>
      <vt:lpstr>Times New Roman</vt:lpstr>
      <vt:lpstr>Office Theme</vt:lpstr>
      <vt:lpstr>1_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smeen El-Sayed Moussa Heikal</dc:creator>
  <cp:lastModifiedBy>Yasmeen El-Sayed Moussa Heikal</cp:lastModifiedBy>
  <cp:revision>5</cp:revision>
  <dcterms:created xsi:type="dcterms:W3CDTF">2024-03-31T07:15:18Z</dcterms:created>
  <dcterms:modified xsi:type="dcterms:W3CDTF">2024-09-25T20:45:00Z</dcterms:modified>
</cp:coreProperties>
</file>